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83720" r:id="rId1"/>
  </p:sldMasterIdLst>
  <p:notesMasterIdLst>
    <p:notesMasterId r:id="rId7"/>
  </p:notesMasterIdLst>
  <p:sldIdLst>
    <p:sldId id="425" r:id="rId2"/>
    <p:sldId id="414" r:id="rId3"/>
    <p:sldId id="410" r:id="rId4"/>
    <p:sldId id="421" r:id="rId5"/>
    <p:sldId id="426" r:id="rId6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45FE2D8B-26A3-2230-4A14-6BC8A6A8D339}" name="Vendrami Colin" initials="CV" userId="S::colin.vendrami@chuv.ch::6561f52e-a582-4a3e-973a-2d4e71f4f01e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F7F7F"/>
    <a:srgbClr val="AF59BA"/>
    <a:srgbClr val="AFABAB"/>
    <a:srgbClr val="F51F5B"/>
    <a:srgbClr val="F8D8CA"/>
    <a:srgbClr val="000000"/>
    <a:srgbClr val="D1E6B5"/>
    <a:srgbClr val="4B4B4B"/>
    <a:srgbClr val="FBC620"/>
    <a:srgbClr val="3FCD6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E3FDE45-AF77-4B5C-9715-49D594BDF05E}" styleName="Style léger 1 - Accentuation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7E9639D4-E3E2-4D34-9284-5A2195B3D0D7}" styleName="Style clair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16DA210-FB5B-4158-B5E0-FEB733F419BA}" styleName="Style clair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F5AB1C69-6EDB-4FF4-983F-18BD219EF322}" styleName="Style moyen 2 - Accentuation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286"/>
    <p:restoredTop sz="92329"/>
  </p:normalViewPr>
  <p:slideViewPr>
    <p:cSldViewPr snapToGrid="0" snapToObjects="1">
      <p:cViewPr>
        <p:scale>
          <a:sx n="126" d="100"/>
          <a:sy n="126" d="100"/>
        </p:scale>
        <p:origin x="992" y="-120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20" d="100"/>
        <a:sy n="20" d="100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EC968B-68A0-4644-9C96-DAC7522094E0}" type="datetimeFigureOut">
              <a:rPr lang="en-GB" smtClean="0"/>
              <a:t>15/03/2025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352FC6-A9C6-7B43-85FE-AADA4137660D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67217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219170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1pPr>
    <a:lvl2pPr marL="609585" algn="l" defTabSz="1219170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2pPr>
    <a:lvl3pPr marL="1219170" algn="l" defTabSz="1219170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3pPr>
    <a:lvl4pPr marL="1828754" algn="l" defTabSz="1219170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4pPr>
    <a:lvl5pPr marL="2438339" algn="l" defTabSz="1219170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5pPr>
    <a:lvl6pPr marL="3047924" algn="l" defTabSz="1219170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6pPr>
    <a:lvl7pPr marL="3657509" algn="l" defTabSz="1219170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7pPr>
    <a:lvl8pPr marL="4267093" algn="l" defTabSz="1219170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8pPr>
    <a:lvl9pPr marL="4876678" algn="l" defTabSz="1219170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3352FC6-A9C6-7B43-85FE-AADA4137660D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451412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3352FC6-A9C6-7B43-85FE-AADA4137660D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483092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3352FC6-A9C6-7B43-85FE-AADA4137660D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66077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38250" y="1122363"/>
            <a:ext cx="74295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11" indent="0" algn="ctr">
              <a:buNone/>
              <a:defRPr sz="2000"/>
            </a:lvl2pPr>
            <a:lvl3pPr marL="914423" indent="0" algn="ctr">
              <a:buNone/>
              <a:defRPr sz="1801"/>
            </a:lvl3pPr>
            <a:lvl4pPr marL="1371634" indent="0" algn="ctr">
              <a:buNone/>
              <a:defRPr sz="1600"/>
            </a:lvl4pPr>
            <a:lvl5pPr marL="1828846" indent="0" algn="ctr">
              <a:buNone/>
              <a:defRPr sz="1600"/>
            </a:lvl5pPr>
            <a:lvl6pPr marL="2286057" indent="0" algn="ctr">
              <a:buNone/>
              <a:defRPr sz="1600"/>
            </a:lvl6pPr>
            <a:lvl7pPr marL="2743269" indent="0" algn="ctr">
              <a:buNone/>
              <a:defRPr sz="1600"/>
            </a:lvl7pPr>
            <a:lvl8pPr marL="3200480" indent="0" algn="ctr">
              <a:buNone/>
              <a:defRPr sz="1600"/>
            </a:lvl8pPr>
            <a:lvl9pPr marL="3657691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F36EA2-0ED2-B243-95C1-639BC0B2D652}" type="datetime1">
              <a:rPr lang="fr-CH" smtClean="0"/>
              <a:t>15.03.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C. Vendrami - ISCD Annual Meeting 2023 - Chicago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DE8B2-960D-5C43-8820-443305420B8A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35791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0DF5-4CF1-DC45-B5EF-F4B5F0DFACA7}" type="datetime1">
              <a:rPr lang="fr-CH" smtClean="0"/>
              <a:t>15.03.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C. Vendrami - ISCD Annual Meeting 2023 - Chicago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DE8B2-960D-5C43-8820-443305420B8A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49604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1" y="365125"/>
            <a:ext cx="2135981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7" y="365125"/>
            <a:ext cx="6284119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C4EFE-2BDE-4440-8D80-AFA34BDF0EB3}" type="datetime1">
              <a:rPr lang="fr-CH" smtClean="0"/>
              <a:t>15.03.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C. Vendrami - ISCD Annual Meeting 2023 - Chicago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DE8B2-960D-5C43-8820-443305420B8A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25845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423EC-3408-CE4F-84E8-CC52A52609E0}" type="datetime1">
              <a:rPr lang="fr-CH" smtClean="0"/>
              <a:t>15.03.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C. Vendrami - ISCD Annual Meeting 2023 - Chicago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DE8B2-960D-5C43-8820-443305420B8A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98608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8" y="1709738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8" y="4589466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1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23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6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5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6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8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9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3A5F1-90D4-1B4A-B59D-45FF0311D6AE}" type="datetime1">
              <a:rPr lang="fr-CH" smtClean="0"/>
              <a:t>15.03.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C. Vendrami - ISCD Annual Meeting 2023 - Chicago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DE8B2-960D-5C43-8820-443305420B8A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04744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3AA24-7377-6944-8130-46F3F3F5AE6A}" type="datetime1">
              <a:rPr lang="fr-CH" smtClean="0"/>
              <a:t>15.03.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C. Vendrami - ISCD Annual Meeting 2023 - Chicago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DE8B2-960D-5C43-8820-443305420B8A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80771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365126"/>
            <a:ext cx="8543925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8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1" indent="0">
              <a:buNone/>
              <a:defRPr sz="2000" b="1"/>
            </a:lvl2pPr>
            <a:lvl3pPr marL="914423" indent="0">
              <a:buNone/>
              <a:defRPr sz="1801" b="1"/>
            </a:lvl3pPr>
            <a:lvl4pPr marL="1371634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9" indent="0">
              <a:buNone/>
              <a:defRPr sz="1600" b="1"/>
            </a:lvl7pPr>
            <a:lvl8pPr marL="3200480" indent="0">
              <a:buNone/>
              <a:defRPr sz="1600" b="1"/>
            </a:lvl8pPr>
            <a:lvl9pPr marL="3657691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8" y="2505075"/>
            <a:ext cx="4190702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1" indent="0">
              <a:buNone/>
              <a:defRPr sz="2000" b="1"/>
            </a:lvl2pPr>
            <a:lvl3pPr marL="914423" indent="0">
              <a:buNone/>
              <a:defRPr sz="1801" b="1"/>
            </a:lvl3pPr>
            <a:lvl4pPr marL="1371634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9" indent="0">
              <a:buNone/>
              <a:defRPr sz="1600" b="1"/>
            </a:lvl7pPr>
            <a:lvl8pPr marL="3200480" indent="0">
              <a:buNone/>
              <a:defRPr sz="1600" b="1"/>
            </a:lvl8pPr>
            <a:lvl9pPr marL="3657691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700BF-532E-8A4E-876A-214EED212330}" type="datetime1">
              <a:rPr lang="fr-CH" smtClean="0"/>
              <a:t>15.03.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C. Vendrami - ISCD Annual Meeting 2023 - Chicago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DE8B2-960D-5C43-8820-443305420B8A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42137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90690-1A0C-8844-B8CB-545D16E38E27}" type="datetime1">
              <a:rPr lang="fr-CH" smtClean="0"/>
              <a:t>15.03.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C. Vendrami - ISCD Annual Meeting 2023 - Chicago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DE8B2-960D-5C43-8820-443305420B8A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18449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262986-314E-F44F-B38A-EDE7FD074A87}" type="datetime1">
              <a:rPr lang="fr-CH" smtClean="0"/>
              <a:t>15.03.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C. Vendrami - ISCD Annual Meeting 2023 - Chicago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DE8B2-960D-5C43-8820-443305420B8A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44814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1" y="987426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9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1" indent="0">
              <a:buNone/>
              <a:defRPr sz="1401"/>
            </a:lvl2pPr>
            <a:lvl3pPr marL="914423" indent="0">
              <a:buNone/>
              <a:defRPr sz="1200"/>
            </a:lvl3pPr>
            <a:lvl4pPr marL="1371634" indent="0">
              <a:buNone/>
              <a:defRPr sz="1001"/>
            </a:lvl4pPr>
            <a:lvl5pPr marL="1828846" indent="0">
              <a:buNone/>
              <a:defRPr sz="1001"/>
            </a:lvl5pPr>
            <a:lvl6pPr marL="2286057" indent="0">
              <a:buNone/>
              <a:defRPr sz="1001"/>
            </a:lvl6pPr>
            <a:lvl7pPr marL="2743269" indent="0">
              <a:buNone/>
              <a:defRPr sz="1001"/>
            </a:lvl7pPr>
            <a:lvl8pPr marL="3200480" indent="0">
              <a:buNone/>
              <a:defRPr sz="1001"/>
            </a:lvl8pPr>
            <a:lvl9pPr marL="3657691" indent="0">
              <a:buNone/>
              <a:defRPr sz="100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D0B070-3B0F-F24C-9490-1BCA1E387636}" type="datetime1">
              <a:rPr lang="fr-CH" smtClean="0"/>
              <a:t>15.03.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C. Vendrami - ISCD Annual Meeting 2023 - Chicago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DE8B2-960D-5C43-8820-443305420B8A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0513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1" y="987426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11" indent="0">
              <a:buNone/>
              <a:defRPr sz="2800"/>
            </a:lvl2pPr>
            <a:lvl3pPr marL="914423" indent="0">
              <a:buNone/>
              <a:defRPr sz="2400"/>
            </a:lvl3pPr>
            <a:lvl4pPr marL="1371634" indent="0">
              <a:buNone/>
              <a:defRPr sz="2000"/>
            </a:lvl4pPr>
            <a:lvl5pPr marL="1828846" indent="0">
              <a:buNone/>
              <a:defRPr sz="2000"/>
            </a:lvl5pPr>
            <a:lvl6pPr marL="2286057" indent="0">
              <a:buNone/>
              <a:defRPr sz="2000"/>
            </a:lvl6pPr>
            <a:lvl7pPr marL="2743269" indent="0">
              <a:buNone/>
              <a:defRPr sz="2000"/>
            </a:lvl7pPr>
            <a:lvl8pPr marL="3200480" indent="0">
              <a:buNone/>
              <a:defRPr sz="2000"/>
            </a:lvl8pPr>
            <a:lvl9pPr marL="3657691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9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1" indent="0">
              <a:buNone/>
              <a:defRPr sz="1401"/>
            </a:lvl2pPr>
            <a:lvl3pPr marL="914423" indent="0">
              <a:buNone/>
              <a:defRPr sz="1200"/>
            </a:lvl3pPr>
            <a:lvl4pPr marL="1371634" indent="0">
              <a:buNone/>
              <a:defRPr sz="1001"/>
            </a:lvl4pPr>
            <a:lvl5pPr marL="1828846" indent="0">
              <a:buNone/>
              <a:defRPr sz="1001"/>
            </a:lvl5pPr>
            <a:lvl6pPr marL="2286057" indent="0">
              <a:buNone/>
              <a:defRPr sz="1001"/>
            </a:lvl6pPr>
            <a:lvl7pPr marL="2743269" indent="0">
              <a:buNone/>
              <a:defRPr sz="1001"/>
            </a:lvl7pPr>
            <a:lvl8pPr marL="3200480" indent="0">
              <a:buNone/>
              <a:defRPr sz="1001"/>
            </a:lvl8pPr>
            <a:lvl9pPr marL="3657691" indent="0">
              <a:buNone/>
              <a:defRPr sz="100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38547-3D98-854E-A579-E06E62E1CE0D}" type="datetime1">
              <a:rPr lang="fr-CH" smtClean="0"/>
              <a:t>15.03.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C. Vendrami - ISCD Annual Meeting 2023 - Chicago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DE8B2-960D-5C43-8820-443305420B8A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4012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6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3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0CAE7E-6EF7-4242-BB03-B6209D0BC2DB}" type="datetime1">
              <a:rPr lang="fr-CH" smtClean="0"/>
              <a:t>15.03.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3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GB"/>
              <a:t>C. Vendrami - ISCD Annual Meeting 2023 - Chicago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3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7DE8B2-960D-5C43-8820-443305420B8A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19918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hf hdr="0" dt="0"/>
  <p:txStyles>
    <p:titleStyle>
      <a:lvl1pPr algn="l" defTabSz="914423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6" indent="-228606" algn="l" defTabSz="914423" rtl="0" eaLnBrk="1" latinLnBrk="0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18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29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41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52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63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875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086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298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2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11" algn="l" defTabSz="91442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23" algn="l" defTabSz="91442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34" algn="l" defTabSz="91442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46" algn="l" defTabSz="91442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057" algn="l" defTabSz="91442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269" algn="l" defTabSz="91442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480" algn="l" defTabSz="91442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691" algn="l" defTabSz="91442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21BCA28A-12E9-0127-8BB0-AE8E2A653B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DE8B2-960D-5C43-8820-443305420B8A}" type="slidenum">
              <a:rPr lang="en-GB" smtClean="0"/>
              <a:t>1</a:t>
            </a:fld>
            <a:endParaRPr lang="en-GB"/>
          </a:p>
        </p:txBody>
      </p:sp>
      <p:graphicFrame>
        <p:nvGraphicFramePr>
          <p:cNvPr id="6" name="Tableau 5">
            <a:extLst>
              <a:ext uri="{FF2B5EF4-FFF2-40B4-BE49-F238E27FC236}">
                <a16:creationId xmlns:a16="http://schemas.microsoft.com/office/drawing/2014/main" id="{516B3570-7633-39A9-4C35-37302A7BBB47}"/>
              </a:ext>
            </a:extLst>
          </p:cNvPr>
          <p:cNvGraphicFramePr>
            <a:graphicFrameLocks noGrp="1"/>
          </p:cNvGraphicFramePr>
          <p:nvPr/>
        </p:nvGraphicFramePr>
        <p:xfrm>
          <a:off x="1570683" y="1824390"/>
          <a:ext cx="6864023" cy="2663575"/>
        </p:xfrm>
        <a:graphic>
          <a:graphicData uri="http://schemas.openxmlformats.org/drawingml/2006/table">
            <a:tbl>
              <a:tblPr firstRow="1" firstCol="1" bandRow="1">
                <a:tableStyleId>{616DA210-FB5B-4158-B5E0-FEB733F419BA}</a:tableStyleId>
              </a:tblPr>
              <a:tblGrid>
                <a:gridCol w="1680023">
                  <a:extLst>
                    <a:ext uri="{9D8B030D-6E8A-4147-A177-3AD203B41FA5}">
                      <a16:colId xmlns:a16="http://schemas.microsoft.com/office/drawing/2014/main" val="3557047117"/>
                    </a:ext>
                  </a:extLst>
                </a:gridCol>
                <a:gridCol w="864000">
                  <a:extLst>
                    <a:ext uri="{9D8B030D-6E8A-4147-A177-3AD203B41FA5}">
                      <a16:colId xmlns:a16="http://schemas.microsoft.com/office/drawing/2014/main" val="3296920545"/>
                    </a:ext>
                  </a:extLst>
                </a:gridCol>
                <a:gridCol w="864000">
                  <a:extLst>
                    <a:ext uri="{9D8B030D-6E8A-4147-A177-3AD203B41FA5}">
                      <a16:colId xmlns:a16="http://schemas.microsoft.com/office/drawing/2014/main" val="26306176"/>
                    </a:ext>
                  </a:extLst>
                </a:gridCol>
                <a:gridCol w="864000">
                  <a:extLst>
                    <a:ext uri="{9D8B030D-6E8A-4147-A177-3AD203B41FA5}">
                      <a16:colId xmlns:a16="http://schemas.microsoft.com/office/drawing/2014/main" val="1695273414"/>
                    </a:ext>
                  </a:extLst>
                </a:gridCol>
                <a:gridCol w="864000">
                  <a:extLst>
                    <a:ext uri="{9D8B030D-6E8A-4147-A177-3AD203B41FA5}">
                      <a16:colId xmlns:a16="http://schemas.microsoft.com/office/drawing/2014/main" val="837746644"/>
                    </a:ext>
                  </a:extLst>
                </a:gridCol>
                <a:gridCol w="864000">
                  <a:extLst>
                    <a:ext uri="{9D8B030D-6E8A-4147-A177-3AD203B41FA5}">
                      <a16:colId xmlns:a16="http://schemas.microsoft.com/office/drawing/2014/main" val="2149811384"/>
                    </a:ext>
                  </a:extLst>
                </a:gridCol>
                <a:gridCol w="864000">
                  <a:extLst>
                    <a:ext uri="{9D8B030D-6E8A-4147-A177-3AD203B41FA5}">
                      <a16:colId xmlns:a16="http://schemas.microsoft.com/office/drawing/2014/main" val="1236382582"/>
                    </a:ext>
                  </a:extLst>
                </a:gridCol>
              </a:tblGrid>
              <a:tr h="160995">
                <a:tc rowSpan="2">
                  <a:txBody>
                    <a:bodyPr/>
                    <a:lstStyle/>
                    <a:p>
                      <a:pPr marL="0" marR="0" lvl="0" indent="0" algn="l" defTabSz="914423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50" b="0" noProof="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ean±SD</a:t>
                      </a:r>
                      <a:endParaRPr lang="en-GB" sz="1050" b="0" noProof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b="0" i="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jor osteoporotic fractures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fr-CH" sz="9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b="0" noProof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Vertebral fractures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b="0" noProof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n vertebral fractures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5487155"/>
                  </a:ext>
                </a:extLst>
              </a:tr>
              <a:tr h="232280">
                <a:tc vMerge="1">
                  <a:txBody>
                    <a:bodyPr/>
                    <a:lstStyle/>
                    <a:p>
                      <a:endParaRPr dirty="0"/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900" b="0" noProof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Yes (</a:t>
                      </a:r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=260)</a:t>
                      </a:r>
                      <a:endParaRPr lang="en-GB" sz="900" b="0" noProof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900" b="0" noProof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 (n=760)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900" b="0" noProof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Yes (n=174)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noProof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 (n=820)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900" b="0" noProof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Yes (n=107)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noProof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 (n=1368)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12171149"/>
                  </a:ext>
                </a:extLst>
              </a:tr>
              <a:tr h="22703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b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GS/arm lean mass </a:t>
                      </a:r>
                      <a:r>
                        <a:rPr lang="en-GB" sz="700" b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kg/kg]</a:t>
                      </a:r>
                      <a:r>
                        <a:rPr lang="en-GB" sz="1000" b="0" baseline="3000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GB" sz="1000" b="0" noProof="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20" marR="9720" marT="9720" marB="972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23" rtl="0" eaLnBrk="1" fontAlgn="b" latinLnBrk="0" hangingPunct="1"/>
                      <a:r>
                        <a:rPr lang="en-GB" sz="1000" b="1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1.5±2.7</a:t>
                      </a:r>
                    </a:p>
                  </a:txBody>
                  <a:tcPr marL="9720" marR="9720" marT="9720" marB="972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23" rtl="0" eaLnBrk="1" fontAlgn="b" latinLnBrk="0" hangingPunct="1"/>
                      <a:r>
                        <a:rPr lang="en-GB" sz="1000" b="1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2.4±2.7**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23" rtl="0" eaLnBrk="1" fontAlgn="b" latinLnBrk="0" hangingPunct="1"/>
                      <a:r>
                        <a:rPr lang="en-GB" sz="10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1.5±2.8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23" rtl="0" eaLnBrk="1" fontAlgn="b" latinLnBrk="0" hangingPunct="1"/>
                      <a:r>
                        <a:rPr lang="en-GB" sz="10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2.4±2.6*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6±2.4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1±2.7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58633265"/>
                  </a:ext>
                </a:extLst>
              </a:tr>
              <a:tr h="22703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b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M/weight </a:t>
                      </a:r>
                      <a:r>
                        <a:rPr lang="en-GB" sz="700" b="0" baseline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kg/kg]</a:t>
                      </a:r>
                      <a:endParaRPr lang="en-GB" sz="700" b="0" noProof="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20" marR="9720" marT="9720" marB="972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6±0.027</a:t>
                      </a:r>
                    </a:p>
                  </a:txBody>
                  <a:tcPr marL="9720" marR="9720" marT="9720" marB="972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63±0.028**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8±0.027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63±0.028*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5±0.028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9±0.028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90402134"/>
                  </a:ext>
                </a:extLst>
              </a:tr>
              <a:tr h="22703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b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M/(height*weight) </a:t>
                      </a:r>
                      <a:r>
                        <a:rPr lang="en-GB" sz="700" b="0" baseline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GB" sz="700" b="0" baseline="3000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r>
                        <a:rPr lang="en-GB" sz="700" b="0" baseline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m</a:t>
                      </a:r>
                      <a:r>
                        <a:rPr lang="en-GB" sz="700" b="0" baseline="3000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GB" sz="700" b="0" baseline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lang="en-GB" sz="1000" b="0" noProof="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20" marR="9720" marT="9720" marB="972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23" rtl="0" eaLnBrk="1" fontAlgn="b" latinLnBrk="0" hangingPunct="1"/>
                      <a:r>
                        <a:rPr lang="en-GB" sz="1000" b="1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158±0.016</a:t>
                      </a:r>
                    </a:p>
                  </a:txBody>
                  <a:tcPr marL="9720" marR="9720" marT="9720" marB="972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23" rtl="0" eaLnBrk="1" fontAlgn="b" latinLnBrk="0" hangingPunct="1"/>
                      <a:r>
                        <a:rPr lang="en-GB" sz="1000" b="1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163±0.017**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23" rtl="0" eaLnBrk="1" fontAlgn="b" latinLnBrk="0" hangingPunct="1"/>
                      <a:r>
                        <a:rPr lang="en-GB" sz="10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159±0.016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23" rtl="0" eaLnBrk="1" fontAlgn="b" latinLnBrk="0" hangingPunct="1"/>
                      <a:r>
                        <a:rPr lang="en-GB" sz="10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162±0.017*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7±0.017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1±0.017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63112078"/>
                  </a:ext>
                </a:extLst>
              </a:tr>
              <a:tr h="22703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b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M percent </a:t>
                      </a:r>
                      <a:r>
                        <a:rPr lang="en-GB" sz="700" b="0" baseline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%]</a:t>
                      </a:r>
                    </a:p>
                  </a:txBody>
                  <a:tcPr marL="9720" marR="9720" marT="9720" marB="972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23" rtl="0" eaLnBrk="1" fontAlgn="b" latinLnBrk="0" hangingPunct="1"/>
                      <a:r>
                        <a:rPr lang="en-GB" sz="10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6.3±5.8</a:t>
                      </a:r>
                    </a:p>
                  </a:txBody>
                  <a:tcPr marL="9720" marR="9720" marT="9720" marB="972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23" rtl="0" eaLnBrk="1" fontAlgn="b" latinLnBrk="0" hangingPunct="1"/>
                      <a:r>
                        <a:rPr lang="en-GB" sz="10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7.5±5.7*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23" rtl="0" eaLnBrk="1" fontAlgn="b" latinLnBrk="0" hangingPunct="1"/>
                      <a:r>
                        <a:rPr lang="en-GB" sz="10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6.7±5.7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23" rtl="0" eaLnBrk="1" fontAlgn="b" latinLnBrk="0" hangingPunct="1"/>
                      <a:r>
                        <a:rPr lang="en-GB" sz="10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7.4±5.7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.0±5.7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.8±5.9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34668512"/>
                  </a:ext>
                </a:extLst>
              </a:tr>
              <a:tr h="227030">
                <a:tc>
                  <a:txBody>
                    <a:bodyPr/>
                    <a:lstStyle/>
                    <a:p>
                      <a:pPr algn="l" fontAlgn="t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body lean mass </a:t>
                      </a:r>
                      <a:r>
                        <a:rPr lang="en-GB" sz="7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kg.]</a:t>
                      </a:r>
                      <a:endParaRPr lang="en-GB" sz="105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20" marR="9720" marT="9720" marB="972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.3±6.0</a:t>
                      </a:r>
                    </a:p>
                  </a:txBody>
                  <a:tcPr marL="9720" marR="9720" marT="9720" marB="972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3±5.1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.8±6.3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3±5.1*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.8±4.4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5±5.4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50053397"/>
                  </a:ext>
                </a:extLst>
              </a:tr>
              <a:tr h="227030">
                <a:tc>
                  <a:txBody>
                    <a:bodyPr/>
                    <a:lstStyle/>
                    <a:p>
                      <a:pPr algn="l" fontAlgn="t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body lean percent </a:t>
                      </a:r>
                      <a:r>
                        <a:rPr lang="en-GB" sz="7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%]</a:t>
                      </a:r>
                      <a:endParaRPr lang="en-GB" sz="105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20" marR="9720" marT="9720" marB="972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3±5.5</a:t>
                      </a:r>
                    </a:p>
                  </a:txBody>
                  <a:tcPr marL="9720" marR="9720" marT="9720" marB="972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.9±5.6**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7±5.8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.8±5.6*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.0±3.2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.1±5.8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94865670"/>
                  </a:ext>
                </a:extLst>
              </a:tr>
              <a:tr h="227030">
                <a:tc>
                  <a:txBody>
                    <a:bodyPr/>
                    <a:lstStyle/>
                    <a:p>
                      <a:pPr algn="l" fontAlgn="t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ms lean mass </a:t>
                      </a:r>
                      <a:r>
                        <a:rPr lang="en-GB" sz="7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kg.]</a:t>
                      </a:r>
                    </a:p>
                  </a:txBody>
                  <a:tcPr marL="9720" marR="9720" marT="9720" marB="972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±0.7</a:t>
                      </a:r>
                    </a:p>
                  </a:txBody>
                  <a:tcPr marL="9720" marR="9720" marT="9720" marB="972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±0.6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±0.7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±0.6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±0.5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±0.6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6695762"/>
                  </a:ext>
                </a:extLst>
              </a:tr>
              <a:tr h="227030">
                <a:tc>
                  <a:txBody>
                    <a:bodyPr/>
                    <a:lstStyle/>
                    <a:p>
                      <a:pPr algn="l" fontAlgn="t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ms lean percent </a:t>
                      </a:r>
                      <a:r>
                        <a:rPr lang="en-GB" sz="7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%]</a:t>
                      </a:r>
                    </a:p>
                  </a:txBody>
                  <a:tcPr marL="9720" marR="9720" marT="9720" marB="972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.8±7.0</a:t>
                      </a:r>
                    </a:p>
                  </a:txBody>
                  <a:tcPr marL="9720" marR="9720" marT="9720" marB="972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.8±7.3**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.5±7.2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.6±7.3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.7±5.1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.8±7.5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95109850"/>
                  </a:ext>
                </a:extLst>
              </a:tr>
              <a:tr h="227030">
                <a:tc>
                  <a:txBody>
                    <a:bodyPr/>
                    <a:lstStyle/>
                    <a:p>
                      <a:pPr algn="l" fontAlgn="t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gs lean mass </a:t>
                      </a:r>
                      <a:r>
                        <a:rPr lang="en-GB" sz="7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kg.]</a:t>
                      </a:r>
                    </a:p>
                  </a:txBody>
                  <a:tcPr marL="9720" marR="9720" marT="9720" marB="972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4±2.2</a:t>
                      </a:r>
                    </a:p>
                  </a:txBody>
                  <a:tcPr marL="9720" marR="9720" marT="9720" marB="972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1±2.0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5±2.3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1±2.0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4±1.4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1±2.1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62146179"/>
                  </a:ext>
                </a:extLst>
              </a:tr>
              <a:tr h="227030">
                <a:tc>
                  <a:txBody>
                    <a:bodyPr/>
                    <a:lstStyle/>
                    <a:p>
                      <a:pPr algn="l" fontAlgn="t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gs lean percent </a:t>
                      </a:r>
                      <a:r>
                        <a:rPr lang="en-GB" sz="7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%]</a:t>
                      </a:r>
                    </a:p>
                  </a:txBody>
                  <a:tcPr marL="9720" marR="9720" marT="9720" marB="972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.9±05.9</a:t>
                      </a:r>
                    </a:p>
                  </a:txBody>
                  <a:tcPr marL="9720" marR="9720" marT="9720" marB="972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.8±5.6*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.2±5.8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.8±5.7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.8±3.5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.1±5.9</a:t>
                      </a: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89817639"/>
                  </a:ext>
                </a:extLst>
              </a:tr>
            </a:tbl>
          </a:graphicData>
        </a:graphic>
      </p:graphicFrame>
      <p:sp>
        <p:nvSpPr>
          <p:cNvPr id="7" name="ZoneTexte 6">
            <a:extLst>
              <a:ext uri="{FF2B5EF4-FFF2-40B4-BE49-F238E27FC236}">
                <a16:creationId xmlns:a16="http://schemas.microsoft.com/office/drawing/2014/main" id="{D4F10CD3-8286-45EF-DCEE-A9817977A1A8}"/>
              </a:ext>
            </a:extLst>
          </p:cNvPr>
          <p:cNvSpPr txBox="1"/>
          <p:nvPr/>
        </p:nvSpPr>
        <p:spPr>
          <a:xfrm>
            <a:off x="1471293" y="4487965"/>
            <a:ext cx="696341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Legend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: SD: Standard Deviation; major osteoporotic fractures defined by low trauma fracture at hip, humerus, forearm and vertebral; vertebral fractures: radiological grades 2-3 or 2 grade 1 fractures; non vertebral fracture: hip, humerus and forearm fractures; yes: event; no: no event; ALM: Appendicular Lean Mass; BMI: Body Mass Index; regional lean percent: regional lean mass / regional mass; regional lean density: regional lean mass / regional area; p-value for a two-sided 95% confidence interval from Wilcoxon-Mann-Whitney test (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: two sided t-test for normally distributed variable); p-value under 0.05 were noted with*, p-value adjusted for Bonferroni under 0.0029 were considered as significant and were noted with 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** and bold</a:t>
            </a:r>
            <a:endParaRPr lang="en-GB" sz="900" b="1" dirty="0">
              <a:highlight>
                <a:srgbClr val="00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642C30A6-0710-26B9-5E1C-052FB0C3AA9C}"/>
              </a:ext>
            </a:extLst>
          </p:cNvPr>
          <p:cNvSpPr txBox="1"/>
          <p:nvPr/>
        </p:nvSpPr>
        <p:spPr>
          <a:xfrm>
            <a:off x="1471293" y="1239615"/>
            <a:ext cx="6963414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55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. Table S1.</a:t>
            </a:r>
            <a:r>
              <a:rPr lang="en-GB" sz="155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Comparison of baseline lean mass assessments between participants with or without fragility fractures in the 10-years follow-up</a:t>
            </a:r>
            <a:endParaRPr lang="en-GB" sz="15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1720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23D4A9C7-0119-CF7C-F275-7A4CDBE76B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DE8B2-960D-5C43-8820-443305420B8A}" type="slidenum">
              <a:rPr lang="en-GB" smtClean="0"/>
              <a:t>2</a:t>
            </a:fld>
            <a:endParaRPr lang="en-GB" dirty="0"/>
          </a:p>
        </p:txBody>
      </p:sp>
      <p:graphicFrame>
        <p:nvGraphicFramePr>
          <p:cNvPr id="6" name="Tableau 5">
            <a:extLst>
              <a:ext uri="{FF2B5EF4-FFF2-40B4-BE49-F238E27FC236}">
                <a16:creationId xmlns:a16="http://schemas.microsoft.com/office/drawing/2014/main" id="{A4DB650E-DDD6-72A4-B85D-FD8A7FBD70A9}"/>
              </a:ext>
            </a:extLst>
          </p:cNvPr>
          <p:cNvGraphicFramePr>
            <a:graphicFrameLocks noGrp="1"/>
          </p:cNvGraphicFramePr>
          <p:nvPr/>
        </p:nvGraphicFramePr>
        <p:xfrm>
          <a:off x="1727166" y="1498343"/>
          <a:ext cx="6451668" cy="3539398"/>
        </p:xfrm>
        <a:graphic>
          <a:graphicData uri="http://schemas.openxmlformats.org/drawingml/2006/table">
            <a:tbl>
              <a:tblPr firstRow="1" firstCol="1" bandRow="1">
                <a:tableStyleId>{616DA210-FB5B-4158-B5E0-FEB733F419BA}</a:tableStyleId>
              </a:tblPr>
              <a:tblGrid>
                <a:gridCol w="1734457">
                  <a:extLst>
                    <a:ext uri="{9D8B030D-6E8A-4147-A177-3AD203B41FA5}">
                      <a16:colId xmlns:a16="http://schemas.microsoft.com/office/drawing/2014/main" val="3557047117"/>
                    </a:ext>
                  </a:extLst>
                </a:gridCol>
                <a:gridCol w="757211">
                  <a:extLst>
                    <a:ext uri="{9D8B030D-6E8A-4147-A177-3AD203B41FA5}">
                      <a16:colId xmlns:a16="http://schemas.microsoft.com/office/drawing/2014/main" val="4010401111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val="2175911014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val="3921240753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val="1562093003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val="1778702242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val="3690040249"/>
                    </a:ext>
                  </a:extLst>
                </a:gridCol>
              </a:tblGrid>
              <a:tr h="105957">
                <a:tc rowSpan="2">
                  <a:txBody>
                    <a:bodyPr/>
                    <a:lstStyle/>
                    <a:p>
                      <a:pPr marL="0" marR="0" lvl="0" indent="0" algn="l" defTabSz="914423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50" b="0" noProof="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ean±SD</a:t>
                      </a:r>
                      <a:endParaRPr lang="en-GB" sz="1050" b="0" noProof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900" b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p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fr-CH" sz="9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900" b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erus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dirty="0"/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23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earm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fr-CH" sz="900" b="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5487155"/>
                  </a:ext>
                </a:extLst>
              </a:tr>
              <a:tr h="211992">
                <a:tc vMerge="1">
                  <a:txBody>
                    <a:bodyPr/>
                    <a:lstStyle/>
                    <a:p>
                      <a:endParaRPr dirty="0"/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noProof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Yes</a:t>
                      </a:r>
                    </a:p>
                    <a:p>
                      <a:pPr marL="0" marR="0" lvl="0" indent="0" algn="ctr" defTabSz="914423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noProof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21)</a:t>
                      </a:r>
                      <a:endParaRPr lang="en-GB" sz="900" b="0" noProof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b="0" noProof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</a:t>
                      </a:r>
                    </a:p>
                    <a:p>
                      <a:pPr marL="0" marR="0" lvl="0" indent="0" algn="ctr" defTabSz="914423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noProof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1452)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b="0" noProof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Yes</a:t>
                      </a:r>
                    </a:p>
                    <a:p>
                      <a:pPr marL="0" marR="0" lvl="0" indent="0" algn="ctr" defTabSz="914423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n=30)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b="0" noProof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</a:t>
                      </a:r>
                    </a:p>
                    <a:p>
                      <a:pPr marL="0" marR="0" lvl="0" indent="0" algn="ctr" defTabSz="914423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noProof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1445)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b="0" noProof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Yes</a:t>
                      </a:r>
                    </a:p>
                    <a:p>
                      <a:pPr marL="0" marR="0" lvl="0" indent="0" algn="ctr" defTabSz="914423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66)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b="0" noProof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</a:t>
                      </a:r>
                    </a:p>
                    <a:p>
                      <a:pPr marL="0" marR="0" lvl="0" indent="0" algn="ctr" defTabSz="914423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noProof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1409)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12171149"/>
                  </a:ext>
                </a:extLst>
              </a:tr>
              <a:tr h="155116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b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GS </a:t>
                      </a:r>
                      <a:r>
                        <a:rPr lang="en-GB" sz="700" b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kg.]</a:t>
                      </a:r>
                      <a:r>
                        <a:rPr lang="en-GB" sz="1000" b="0" baseline="3000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GB" sz="700" b="0" baseline="30000" noProof="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9720" marB="972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5±6.7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0±5.9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9±5.8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9±5.9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7±6.2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0±5.9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50053397"/>
                  </a:ext>
                </a:extLst>
              </a:tr>
              <a:tr h="155116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b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GS/arm lean mass </a:t>
                      </a:r>
                      <a:r>
                        <a:rPr lang="en-GB" sz="700" b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kg/kg]</a:t>
                      </a:r>
                      <a:r>
                        <a:rPr lang="en-GB" sz="1000" b="0" baseline="3000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45720" marR="45720" marT="9720" marB="972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23" rtl="0" eaLnBrk="1" fontAlgn="b" latinLnBrk="0" hangingPunct="1"/>
                      <a:r>
                        <a:rPr lang="en-GB" sz="900" b="0" i="0" u="none" strike="noStrike" kern="1200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0.6±1.8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23" rtl="0" eaLnBrk="1" fontAlgn="b" latinLnBrk="0" hangingPunct="1"/>
                      <a:r>
                        <a:rPr lang="en-GB" sz="900" b="0" i="0" u="none" strike="noStrike" kern="1200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2.0±2.7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7±2.8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0±2.7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5±2.3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0±2.7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94865670"/>
                  </a:ext>
                </a:extLst>
              </a:tr>
              <a:tr h="155116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b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M </a:t>
                      </a:r>
                      <a:r>
                        <a:rPr lang="en-GB" sz="700" b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kg.]</a:t>
                      </a:r>
                    </a:p>
                  </a:txBody>
                  <a:tcPr marL="45720" marR="45720" marT="9720" marB="972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3±1.9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1±2.6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4±2.8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1±2.6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0±2.6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1±2.6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4294383"/>
                  </a:ext>
                </a:extLst>
              </a:tr>
              <a:tr h="155116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b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M/height</a:t>
                      </a:r>
                      <a:r>
                        <a:rPr lang="en-GB" sz="1000" b="0" baseline="3000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GB" sz="1000" b="0" baseline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700" b="0" baseline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kg/m]</a:t>
                      </a:r>
                    </a:p>
                  </a:txBody>
                  <a:tcPr marL="45720" marR="45720" marT="9720" marB="972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17±0.41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56±0.85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71±0.85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55±0.84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46±0.81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56±0.84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6695762"/>
                  </a:ext>
                </a:extLst>
              </a:tr>
              <a:tr h="155116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b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M/weight </a:t>
                      </a:r>
                      <a:r>
                        <a:rPr lang="en-GB" sz="700" b="0" baseline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kg/kg]</a:t>
                      </a:r>
                      <a:endParaRPr lang="en-GB" sz="700" b="0" noProof="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9720" marB="972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48±0.019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9±0.028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49±0.031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9±0.028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7±0.029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9±0.028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95109850"/>
                  </a:ext>
                </a:extLst>
              </a:tr>
              <a:tr h="155116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b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M/BMI </a:t>
                      </a:r>
                      <a:r>
                        <a:rPr lang="en-GB" sz="700" b="0" baseline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GB" sz="700" b="0" baseline="3000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r>
                        <a:rPr lang="en-GB" sz="700" b="0" baseline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m</a:t>
                      </a:r>
                      <a:r>
                        <a:rPr lang="en-GB" sz="700" b="0" baseline="3000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GB" sz="700" b="0" baseline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lang="en-GB" sz="700" b="0" noProof="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9720" marB="972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7±0.077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7±0.104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49±0.118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8±0.103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9±0.111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7±0.103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98831833"/>
                  </a:ext>
                </a:extLst>
              </a:tr>
              <a:tr h="155116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b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M/(height*weight) </a:t>
                      </a:r>
                      <a:r>
                        <a:rPr lang="en-GB" sz="700" b="0" baseline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GB" sz="700" b="0" baseline="3000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r>
                        <a:rPr lang="en-GB" sz="700" b="0" baseline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m</a:t>
                      </a:r>
                      <a:r>
                        <a:rPr lang="en-GB" sz="700" b="0" baseline="3000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GB" sz="700" b="0" baseline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lang="en-GB" sz="1000" b="0" noProof="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9720" marB="972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23" rtl="0" eaLnBrk="1" fontAlgn="b" latinLnBrk="0" hangingPunct="1"/>
                      <a:r>
                        <a:rPr lang="en-GB" sz="900" b="0" i="0" u="none" strike="noStrike" kern="1200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153±0.014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23" rtl="0" eaLnBrk="1" fontAlgn="b" latinLnBrk="0" hangingPunct="1"/>
                      <a:r>
                        <a:rPr lang="en-GB" sz="900" b="0" i="0" u="none" strike="noStrike" kern="1200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16±0.017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4±0.017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±0.017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9±0.019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±0.017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62146179"/>
                  </a:ext>
                </a:extLst>
              </a:tr>
              <a:tr h="155116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b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M percent </a:t>
                      </a:r>
                      <a:r>
                        <a:rPr lang="en-GB" sz="700" b="0" baseline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%]</a:t>
                      </a:r>
                    </a:p>
                  </a:txBody>
                  <a:tcPr marL="45720" marR="45720" marT="9720" marB="972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23" rtl="0" eaLnBrk="1" fontAlgn="b" latinLnBrk="0" hangingPunct="1"/>
                      <a:r>
                        <a:rPr lang="en-GB" sz="9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5.5±0.037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23" rtl="0" eaLnBrk="1" fontAlgn="b" latinLnBrk="0" hangingPunct="1"/>
                      <a:r>
                        <a:rPr lang="en-GB" sz="9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6.7±5.9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.8±6.8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.7±5.9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.7±6.1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.8±5.9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89817639"/>
                  </a:ext>
                </a:extLst>
              </a:tr>
              <a:tr h="155116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b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M density </a:t>
                      </a:r>
                      <a:r>
                        <a:rPr lang="en-GB" sz="700" b="0" baseline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gr/cm</a:t>
                      </a:r>
                      <a:r>
                        <a:rPr lang="en-GB" sz="700" b="0" baseline="3000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GB" sz="700" b="0" baseline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lang="en-GB" sz="700" b="0" noProof="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9720" marB="972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23" rtl="0" eaLnBrk="1" fontAlgn="b" latinLnBrk="0" hangingPunct="1"/>
                      <a:r>
                        <a:rPr lang="en-GB" sz="900" b="0" i="0" u="none" strike="noStrike" kern="1200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5.2±1.1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23" rtl="0" eaLnBrk="1" fontAlgn="b" latinLnBrk="0" hangingPunct="1"/>
                      <a:r>
                        <a:rPr lang="en-GB" sz="900" b="0" i="0" u="none" strike="noStrike" kern="1200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5.7±1.7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3±1.9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7±1.6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6±1.6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7±1.6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86757972"/>
                  </a:ext>
                </a:extLst>
              </a:tr>
              <a:tr h="155116">
                <a:tc>
                  <a:txBody>
                    <a:bodyPr/>
                    <a:lstStyle/>
                    <a:p>
                      <a:pPr algn="l" fontAlgn="t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body lean mass </a:t>
                      </a:r>
                      <a:r>
                        <a:rPr lang="en-GB" sz="7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kg.]</a:t>
                      </a:r>
                      <a:endParaRPr lang="en-GB" sz="105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9720" marB="972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.8±4.4</a:t>
                      </a:r>
                    </a:p>
                  </a:txBody>
                  <a:tcPr marL="45720" marR="45720" marT="9720" marB="9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5±5.4</a:t>
                      </a:r>
                    </a:p>
                  </a:txBody>
                  <a:tcPr marL="45720" marR="45720" marT="9720" marB="9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.4±5.9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5±5.4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.9±5.4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5±5.4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71252146"/>
                  </a:ext>
                </a:extLst>
              </a:tr>
              <a:tr h="155116">
                <a:tc>
                  <a:txBody>
                    <a:bodyPr/>
                    <a:lstStyle/>
                    <a:p>
                      <a:pPr algn="l" fontAlgn="t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body lean percent </a:t>
                      </a:r>
                      <a:r>
                        <a:rPr lang="en-GB" sz="7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%]</a:t>
                      </a:r>
                      <a:endParaRPr lang="en-GB" sz="105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9720" marB="972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.0±3.2</a:t>
                      </a:r>
                    </a:p>
                  </a:txBody>
                  <a:tcPr marL="45720" marR="45720" marT="9720" marB="9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.1±5.8</a:t>
                      </a:r>
                    </a:p>
                  </a:txBody>
                  <a:tcPr marL="45720" marR="45720" marT="9720" marB="9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.1±6.1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.1±5.7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6±5.8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.1±5.7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56348053"/>
                  </a:ext>
                </a:extLst>
              </a:tr>
              <a:tr h="155116">
                <a:tc>
                  <a:txBody>
                    <a:bodyPr/>
                    <a:lstStyle/>
                    <a:p>
                      <a:pPr algn="l" fontAlgn="t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body lean density</a:t>
                      </a:r>
                      <a:r>
                        <a:rPr lang="en-GB" sz="6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gr/cm</a:t>
                      </a:r>
                      <a:r>
                        <a:rPr lang="en-GB" sz="600" b="0" i="0" u="none" strike="noStrike" baseline="30000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GB" sz="6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9720" marB="972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5±1.1</a:t>
                      </a:r>
                    </a:p>
                  </a:txBody>
                  <a:tcPr marL="45720" marR="45720" marT="9720" marB="9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9±1.9</a:t>
                      </a:r>
                    </a:p>
                  </a:txBody>
                  <a:tcPr marL="45720" marR="45720" marT="9720" marB="9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8±2.2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9±1.8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8±1.7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9±1.9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1338477"/>
                  </a:ext>
                </a:extLst>
              </a:tr>
              <a:tr h="155116">
                <a:tc>
                  <a:txBody>
                    <a:bodyPr/>
                    <a:lstStyle/>
                    <a:p>
                      <a:pPr algn="l" fontAlgn="t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ms lean mass </a:t>
                      </a:r>
                      <a:r>
                        <a:rPr lang="en-GB" sz="7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kg.]</a:t>
                      </a:r>
                    </a:p>
                  </a:txBody>
                  <a:tcPr marL="45720" marR="45720" marT="9720" marB="972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±0.5</a:t>
                      </a:r>
                    </a:p>
                  </a:txBody>
                  <a:tcPr marL="45720" marR="45720" marT="9720" marB="9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±0.6</a:t>
                      </a:r>
                    </a:p>
                  </a:txBody>
                  <a:tcPr marL="45720" marR="45720" marT="9720" marB="9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±0.7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±0.6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±0.6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±0.6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59702110"/>
                  </a:ext>
                </a:extLst>
              </a:tr>
              <a:tr h="155116">
                <a:tc>
                  <a:txBody>
                    <a:bodyPr/>
                    <a:lstStyle/>
                    <a:p>
                      <a:pPr algn="l" fontAlgn="t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ms lean percent </a:t>
                      </a:r>
                      <a:r>
                        <a:rPr lang="en-GB" sz="7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%]</a:t>
                      </a:r>
                    </a:p>
                  </a:txBody>
                  <a:tcPr marL="45720" marR="45720" marT="9720" marB="972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.7±5.1</a:t>
                      </a:r>
                    </a:p>
                  </a:txBody>
                  <a:tcPr marL="45720" marR="45720" marT="9720" marB="9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.8±7.5</a:t>
                      </a:r>
                    </a:p>
                  </a:txBody>
                  <a:tcPr marL="45720" marR="45720" marT="9720" marB="9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.5±8.4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.8±7.4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.4±6.9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.8±7.5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0472523"/>
                  </a:ext>
                </a:extLst>
              </a:tr>
              <a:tr h="155116">
                <a:tc>
                  <a:txBody>
                    <a:bodyPr/>
                    <a:lstStyle/>
                    <a:p>
                      <a:pPr algn="l" fontAlgn="t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ms lean density </a:t>
                      </a:r>
                      <a:r>
                        <a:rPr lang="en-GB" sz="7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gr/cm</a:t>
                      </a:r>
                      <a:r>
                        <a:rPr lang="en-GB" sz="700" b="0" i="0" u="none" strike="noStrike" baseline="30000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GB" sz="7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</a:p>
                  </a:txBody>
                  <a:tcPr marL="45720" marR="45720" marT="9720" marB="972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1±1.1</a:t>
                      </a:r>
                    </a:p>
                  </a:txBody>
                  <a:tcPr marL="45720" marR="45720" marT="9720" marB="9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0±1.2</a:t>
                      </a:r>
                    </a:p>
                  </a:txBody>
                  <a:tcPr marL="45720" marR="45720" marT="9720" marB="9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5±1.5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0±1.2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9±1.2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0±1.2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57807972"/>
                  </a:ext>
                </a:extLst>
              </a:tr>
              <a:tr h="155116">
                <a:tc>
                  <a:txBody>
                    <a:bodyPr/>
                    <a:lstStyle/>
                    <a:p>
                      <a:pPr algn="l" fontAlgn="t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gs lean mass </a:t>
                      </a:r>
                      <a:r>
                        <a:rPr lang="en-GB" sz="7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kg.]</a:t>
                      </a:r>
                    </a:p>
                  </a:txBody>
                  <a:tcPr marL="45720" marR="45720" marT="9720" marB="972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4±1.4</a:t>
                      </a:r>
                    </a:p>
                  </a:txBody>
                  <a:tcPr marL="45720" marR="45720" marT="9720" marB="9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1±2.1</a:t>
                      </a:r>
                    </a:p>
                  </a:txBody>
                  <a:tcPr marL="45720" marR="45720" marT="9720" marB="9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3±2.1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1±2.1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0±2.1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1±2.1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5716151"/>
                  </a:ext>
                </a:extLst>
              </a:tr>
              <a:tr h="155116">
                <a:tc>
                  <a:txBody>
                    <a:bodyPr/>
                    <a:lstStyle/>
                    <a:p>
                      <a:pPr algn="l" fontAlgn="t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gs lean percent </a:t>
                      </a:r>
                      <a:r>
                        <a:rPr lang="en-GB" sz="7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%]</a:t>
                      </a:r>
                    </a:p>
                  </a:txBody>
                  <a:tcPr marL="45720" marR="45720" marT="9720" marB="972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.8±0.035</a:t>
                      </a:r>
                    </a:p>
                  </a:txBody>
                  <a:tcPr marL="45720" marR="45720" marT="9720" marB="9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.1±5.9</a:t>
                      </a:r>
                    </a:p>
                  </a:txBody>
                  <a:tcPr marL="45720" marR="45720" marT="9720" marB="9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.7±7.3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.1±5.8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.2±6.2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.1±5.8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91470047"/>
                  </a:ext>
                </a:extLst>
              </a:tr>
              <a:tr h="155116">
                <a:tc>
                  <a:txBody>
                    <a:bodyPr/>
                    <a:lstStyle/>
                    <a:p>
                      <a:pPr algn="l" fontAlgn="t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gs lean density </a:t>
                      </a:r>
                      <a:r>
                        <a:rPr lang="en-GB" sz="7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gr/cm</a:t>
                      </a:r>
                      <a:r>
                        <a:rPr lang="en-GB" sz="700" b="0" i="0" u="none" strike="noStrike" baseline="30000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GB" sz="7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</a:p>
                  </a:txBody>
                  <a:tcPr marL="45720" marR="45720" marT="9720" marB="972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3±1.2</a:t>
                      </a:r>
                    </a:p>
                  </a:txBody>
                  <a:tcPr marL="45720" marR="45720" marT="9720" marB="9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1±2.2</a:t>
                      </a:r>
                    </a:p>
                  </a:txBody>
                  <a:tcPr marL="45720" marR="45720" marT="9720" marB="9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7±2.4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0±2.2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9±2.1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1±2.2</a:t>
                      </a:r>
                    </a:p>
                  </a:txBody>
                  <a:tcPr marL="45720" marR="45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80715604"/>
                  </a:ext>
                </a:extLst>
              </a:tr>
            </a:tbl>
          </a:graphicData>
        </a:graphic>
      </p:graphicFrame>
      <p:sp>
        <p:nvSpPr>
          <p:cNvPr id="7" name="ZoneTexte 6">
            <a:extLst>
              <a:ext uri="{FF2B5EF4-FFF2-40B4-BE49-F238E27FC236}">
                <a16:creationId xmlns:a16="http://schemas.microsoft.com/office/drawing/2014/main" id="{23A5E199-FE6B-7510-2039-972C94DC9772}"/>
              </a:ext>
            </a:extLst>
          </p:cNvPr>
          <p:cNvSpPr txBox="1"/>
          <p:nvPr/>
        </p:nvSpPr>
        <p:spPr>
          <a:xfrm>
            <a:off x="1676087" y="667346"/>
            <a:ext cx="6502747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55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. Table S2</a:t>
            </a:r>
            <a:r>
              <a:rPr lang="en-GB" sz="155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Comparison of baseline muscle strength and lean mass assessments between participants with or without hip, humerus or forearm fractures in the 10-years follow-up</a:t>
            </a:r>
            <a:endParaRPr lang="en-GB" sz="15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ADF67BDB-3E67-DA01-2B0E-EA5D48A85FBC}"/>
              </a:ext>
            </a:extLst>
          </p:cNvPr>
          <p:cNvSpPr txBox="1"/>
          <p:nvPr/>
        </p:nvSpPr>
        <p:spPr>
          <a:xfrm>
            <a:off x="1658869" y="5037741"/>
            <a:ext cx="66030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Legend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: SD: Standard deviation; yes: event; no: no event; ALM: Appendicular Lean Mass; BMI: Body Mass Index; ALM percent: ALM /appendicular total mass, ALM density: ALM/appendicular area; HGS: Handgrip Strength; p-value for a two-sided 95% confidence interval from Wilcoxon-Mann-Whitney test (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: two sided t-test for normally distributed variable); all p-values were over 0.05 and not significant.</a:t>
            </a:r>
            <a:endParaRPr lang="en-GB" sz="900" b="1" dirty="0">
              <a:highlight>
                <a:srgbClr val="00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89238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687A7A9-BCAA-8135-BF72-BD6B344CE4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227931" y="246937"/>
            <a:ext cx="6042569" cy="445633"/>
          </a:xfrm>
        </p:spPr>
        <p:txBody>
          <a:bodyPr>
            <a:noAutofit/>
          </a:bodyPr>
          <a:lstStyle/>
          <a:p>
            <a:r>
              <a:rPr lang="en-GB" sz="155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w: </a:t>
            </a:r>
            <a:r>
              <a:rPr lang="en-GB" sz="1550" b="1" dirty="0">
                <a:latin typeface="Arial" panose="020B0604020202020204" pitchFamily="34" charset="0"/>
                <a:cs typeface="Arial" panose="020B0604020202020204" pitchFamily="34" charset="0"/>
              </a:rPr>
              <a:t>Supp. Table S3. </a:t>
            </a:r>
            <a:r>
              <a:rPr lang="en-GB" sz="1550" dirty="0">
                <a:latin typeface="Arial" panose="020B0604020202020204" pitchFamily="34" charset="0"/>
                <a:cs typeface="Arial" panose="020B0604020202020204" pitchFamily="34" charset="0"/>
              </a:rPr>
              <a:t>Prediction of 10 years incident fragility fractures by lean mass with accelerated failure time model</a:t>
            </a:r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425A048E-2B61-9976-D0A1-BB93748EA8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7730420" y="6516748"/>
            <a:ext cx="2228850" cy="365125"/>
          </a:xfrm>
        </p:spPr>
        <p:txBody>
          <a:bodyPr/>
          <a:lstStyle/>
          <a:p>
            <a:fld id="{487DE8B2-960D-5C43-8820-443305420B8A}" type="slidenum">
              <a:rPr lang="en-GB" smtClean="0"/>
              <a:t>3</a:t>
            </a:fld>
            <a:endParaRPr lang="en-GB"/>
          </a:p>
        </p:txBody>
      </p:sp>
      <p:graphicFrame>
        <p:nvGraphicFramePr>
          <p:cNvPr id="6" name="Tableau 5">
            <a:extLst>
              <a:ext uri="{FF2B5EF4-FFF2-40B4-BE49-F238E27FC236}">
                <a16:creationId xmlns:a16="http://schemas.microsoft.com/office/drawing/2014/main" id="{E8BDB7C2-0AB8-8FB9-5700-3A4CC15C862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06799328"/>
              </p:ext>
            </p:extLst>
          </p:nvPr>
        </p:nvGraphicFramePr>
        <p:xfrm>
          <a:off x="2314979" y="692570"/>
          <a:ext cx="5937868" cy="440406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800583">
                  <a:extLst>
                    <a:ext uri="{9D8B030D-6E8A-4147-A177-3AD203B41FA5}">
                      <a16:colId xmlns:a16="http://schemas.microsoft.com/office/drawing/2014/main" val="3164648341"/>
                    </a:ext>
                  </a:extLst>
                </a:gridCol>
                <a:gridCol w="273366">
                  <a:extLst>
                    <a:ext uri="{9D8B030D-6E8A-4147-A177-3AD203B41FA5}">
                      <a16:colId xmlns:a16="http://schemas.microsoft.com/office/drawing/2014/main" val="2435339739"/>
                    </a:ext>
                  </a:extLst>
                </a:gridCol>
                <a:gridCol w="818503">
                  <a:extLst>
                    <a:ext uri="{9D8B030D-6E8A-4147-A177-3AD203B41FA5}">
                      <a16:colId xmlns:a16="http://schemas.microsoft.com/office/drawing/2014/main" val="3384724136"/>
                    </a:ext>
                  </a:extLst>
                </a:gridCol>
                <a:gridCol w="433952">
                  <a:extLst>
                    <a:ext uri="{9D8B030D-6E8A-4147-A177-3AD203B41FA5}">
                      <a16:colId xmlns:a16="http://schemas.microsoft.com/office/drawing/2014/main" val="1193085381"/>
                    </a:ext>
                  </a:extLst>
                </a:gridCol>
                <a:gridCol w="910273">
                  <a:extLst>
                    <a:ext uri="{9D8B030D-6E8A-4147-A177-3AD203B41FA5}">
                      <a16:colId xmlns:a16="http://schemas.microsoft.com/office/drawing/2014/main" val="1188719714"/>
                    </a:ext>
                  </a:extLst>
                </a:gridCol>
                <a:gridCol w="407083">
                  <a:extLst>
                    <a:ext uri="{9D8B030D-6E8A-4147-A177-3AD203B41FA5}">
                      <a16:colId xmlns:a16="http://schemas.microsoft.com/office/drawing/2014/main" val="3118407336"/>
                    </a:ext>
                  </a:extLst>
                </a:gridCol>
                <a:gridCol w="834483">
                  <a:extLst>
                    <a:ext uri="{9D8B030D-6E8A-4147-A177-3AD203B41FA5}">
                      <a16:colId xmlns:a16="http://schemas.microsoft.com/office/drawing/2014/main" val="3966627800"/>
                    </a:ext>
                  </a:extLst>
                </a:gridCol>
                <a:gridCol w="459625">
                  <a:extLst>
                    <a:ext uri="{9D8B030D-6E8A-4147-A177-3AD203B41FA5}">
                      <a16:colId xmlns:a16="http://schemas.microsoft.com/office/drawing/2014/main" val="1820650285"/>
                    </a:ext>
                  </a:extLst>
                </a:gridCol>
              </a:tblGrid>
              <a:tr h="121248"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800" b="0" i="0" u="none" strike="noStrike" noProof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jor osteoporotic fractures </a:t>
                      </a:r>
                      <a:r>
                        <a:rPr lang="en-GB" sz="8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260)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t"/>
                      <a:endParaRPr lang="fr-CH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12700" cmpd="sng">
                      <a:noFill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t"/>
                      <a:r>
                        <a:rPr lang="en-GB" sz="800" b="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tebral fractures</a:t>
                      </a:r>
                    </a:p>
                    <a:p>
                      <a:pPr algn="ctr" fontAlgn="t"/>
                      <a:r>
                        <a:rPr lang="en-GB" sz="800" b="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G2-3 or 2xG1, n=174)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t"/>
                      <a:endParaRPr lang="fr-CH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12700" cmpd="sng">
                      <a:noFill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 vertebral fractures</a:t>
                      </a:r>
                    </a:p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07)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t"/>
                      <a:endParaRPr lang="fr-CH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12700" cmpd="sng">
                      <a:noFill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2880486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t"/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T </a:t>
                      </a:r>
                      <a:r>
                        <a:rPr lang="en-GB" sz="8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lang="en-GB" sz="8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-index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T</a:t>
                      </a:r>
                      <a:r>
                        <a:rPr lang="en-GB" sz="8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95% CI)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-Index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T</a:t>
                      </a:r>
                      <a:r>
                        <a:rPr lang="en-GB" sz="8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95% CI)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-Index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13539220"/>
                  </a:ext>
                </a:extLst>
              </a:tr>
              <a:tr h="61486">
                <a:tc rowSpan="3"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b="1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GS/arm lean mass </a:t>
                      </a:r>
                      <a:r>
                        <a:rPr lang="en-GB" sz="700" b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kg/kg]</a:t>
                      </a:r>
                      <a:r>
                        <a:rPr lang="en-GB" sz="1000" b="0" baseline="3000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GB" sz="1000" b="0" noProof="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20" marR="9720" marT="9720" marB="9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1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6 (1.09 - 1.47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1 (1.01 - 1.44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7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1 (1.06 - 2.16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0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5223457"/>
                  </a:ext>
                </a:extLst>
              </a:tr>
              <a:tr h="61486">
                <a:tc vMerge="1"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700" b="0" noProof="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2</a:t>
                      </a:r>
                      <a:endParaRPr lang="en-GB" sz="800" b="1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6 (1.00 - 1.35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1 (0.93 - 1.32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1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2 (0.93 - 1.87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1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8336185"/>
                  </a:ext>
                </a:extLst>
              </a:tr>
              <a:tr h="61486">
                <a:tc vMerge="1"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000" b="0" noProof="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3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5 (0.99 - 1.34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9 (0.91 - 1.31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1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7 (0.96 - 1.95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5496089"/>
                  </a:ext>
                </a:extLst>
              </a:tr>
              <a:tr h="61486">
                <a:tc rowSpan="3"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b="1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M/weight </a:t>
                      </a:r>
                      <a:r>
                        <a:rPr lang="en-GB" sz="700" b="0" baseline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kg/kg]</a:t>
                      </a:r>
                      <a:endParaRPr lang="en-GB" sz="700" b="0" noProof="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20" marR="9720" marT="9720" marB="9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1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6 (1.08 - 1.47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4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2 (0.94 - 1.33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2 (1.20 - 2.45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1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1551407"/>
                  </a:ext>
                </a:extLst>
              </a:tr>
              <a:tr h="61486">
                <a:tc vMerge="1"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000" b="0" noProof="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2</a:t>
                      </a:r>
                      <a:endParaRPr lang="en-GB" sz="800" b="1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0 (1.02 - 1.41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1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 (0.82 - 1.19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9 (1.18 - 2.40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4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840169"/>
                  </a:ext>
                </a:extLst>
              </a:tr>
              <a:tr h="61486">
                <a:tc vMerge="1"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700" b="0" baseline="0" noProof="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20" marR="9720" marT="9720" marB="9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3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8 (1.01 - 1.39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 (0.81 - 1.18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1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4 (1.15 - 2.34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85859811"/>
                  </a:ext>
                </a:extLst>
              </a:tr>
              <a:tr h="61486">
                <a:tc rowSpan="3">
                  <a:txBody>
                    <a:bodyPr/>
                    <a:lstStyle/>
                    <a:p>
                      <a:pPr marL="0" marR="0" lvl="0" indent="0" algn="l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M /(height*weight)</a:t>
                      </a:r>
                      <a:r>
                        <a:rPr lang="en-GB" sz="1000" b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700" b="0" baseline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</a:t>
                      </a:r>
                      <a:r>
                        <a:rPr lang="en-GB" sz="700" b="0" baseline="3000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r>
                        <a:rPr lang="en-GB" sz="700" b="0" baseline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m</a:t>
                      </a:r>
                      <a:r>
                        <a:rPr lang="en-GB" sz="700" b="0" baseline="3000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GB" sz="700" b="0" baseline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lang="en-GB" sz="1000" b="0" noProof="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1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7 (1.09 - 1.48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1 (0.93 - 1.32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1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2 (1.21 - 2.46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58617133"/>
                  </a:ext>
                </a:extLst>
              </a:tr>
              <a:tr h="61486">
                <a:tc vMerge="1">
                  <a:txBody>
                    <a:bodyPr/>
                    <a:lstStyle/>
                    <a:p>
                      <a:pPr marL="0" marR="0" lvl="0" indent="0" algn="l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2</a:t>
                      </a:r>
                      <a:endParaRPr lang="en-GB" sz="800" b="1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0 (1.02 - 1.40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1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 (0.83 - 1.19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6 (1.18 - 2.34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2259736"/>
                  </a:ext>
                </a:extLst>
              </a:tr>
              <a:tr h="61486">
                <a:tc vMerge="1">
                  <a:txBody>
                    <a:bodyPr/>
                    <a:lstStyle/>
                    <a:p>
                      <a:pPr marL="0" marR="0" lvl="0" indent="0" algn="l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3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8 (1.01 - 1.37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 (0.82 - 1.18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1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2 (1.14 - 2.29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83972554"/>
                  </a:ext>
                </a:extLst>
              </a:tr>
              <a:tr h="61486">
                <a:tc rowSpan="3">
                  <a:txBody>
                    <a:bodyPr/>
                    <a:lstStyle/>
                    <a:p>
                      <a:pPr marL="0" marR="0" lvl="0" indent="0" algn="l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M percent </a:t>
                      </a:r>
                      <a:r>
                        <a:rPr lang="en-GB" sz="700" b="0" baseline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%]</a:t>
                      </a: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1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0 (1.03 - 1.39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64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9 (0.92 - 1.29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38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6 (1.12 - 2.19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0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42251226"/>
                  </a:ext>
                </a:extLst>
              </a:tr>
              <a:tr h="61486">
                <a:tc vMerge="1">
                  <a:txBody>
                    <a:bodyPr/>
                    <a:lstStyle/>
                    <a:p>
                      <a:pPr marL="0" marR="0" lvl="0" indent="0" algn="l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2</a:t>
                      </a:r>
                      <a:endParaRPr lang="en-GB" sz="800" b="1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6 (1.00 - 1.35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1 (0.85 - 1.20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1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5 (1.11 - 2.16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8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2565230"/>
                  </a:ext>
                </a:extLst>
              </a:tr>
              <a:tr h="61486">
                <a:tc vMerge="1">
                  <a:txBody>
                    <a:bodyPr/>
                    <a:lstStyle/>
                    <a:p>
                      <a:pPr marL="0" marR="0" lvl="0" indent="0" algn="l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3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7 (1.00 - 1.36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4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1 (0.85 - 1.21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6 (1.11 - 2.19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91994644"/>
                  </a:ext>
                </a:extLst>
              </a:tr>
              <a:tr h="61486">
                <a:tc rowSpan="3">
                  <a:txBody>
                    <a:bodyPr/>
                    <a:lstStyle/>
                    <a:p>
                      <a:pPr marL="0" marR="0" lvl="0" indent="0" algn="l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body lean mass </a:t>
                      </a:r>
                      <a:r>
                        <a:rPr lang="en-GB" sz="700" b="0" baseline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kg]</a:t>
                      </a:r>
                      <a:endParaRPr lang="en-GB" sz="7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1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 (0.75 - 1.00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3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4 (0.71 - 0.99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4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4 (0.76 - 1.44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0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17021178"/>
                  </a:ext>
                </a:extLst>
              </a:tr>
              <a:tr h="6148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2</a:t>
                      </a:r>
                      <a:endParaRPr lang="en-GB" sz="800" b="1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 (0.59 - 0.83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8 (0.55 - 0.83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1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 (0.50 - 1.09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27316985"/>
                  </a:ext>
                </a:extLst>
              </a:tr>
              <a:tr h="6148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3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 (0.59 - 0.83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1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 (0.55 - 0.83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1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 (0.51 - 1.13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8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25359527"/>
                  </a:ext>
                </a:extLst>
              </a:tr>
              <a:tr h="61486">
                <a:tc rowSpan="3">
                  <a:txBody>
                    <a:bodyPr/>
                    <a:lstStyle/>
                    <a:p>
                      <a:pPr marL="0" marR="0" lvl="0" indent="0" algn="l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body lean percent </a:t>
                      </a:r>
                      <a:r>
                        <a:rPr lang="en-GB" sz="700" b="0" baseline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%]</a:t>
                      </a:r>
                      <a:endParaRPr lang="en-GB" sz="7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1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6 (1.08 - 1.47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4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3 (0.95 - 1.35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7 (1.17 - 2.36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41798647"/>
                  </a:ext>
                </a:extLst>
              </a:tr>
              <a:tr h="61486">
                <a:tc vMerge="1">
                  <a:txBody>
                    <a:bodyPr/>
                    <a:lstStyle/>
                    <a:p>
                      <a:pPr algn="ctr" fontAlgn="t"/>
                      <a:endParaRPr lang="fr-CH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lnL w="12700" cmpd="sng"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u="none" strike="noStrike" noProof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2</a:t>
                      </a:r>
                      <a:endParaRPr lang="en-GB" sz="800" b="1" i="0" u="none" strike="noStrike" noProof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4 (1.07 - 1.45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6 (0.89 - 1.27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1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1 (1.21 - 2.41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8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04832177"/>
                  </a:ext>
                </a:extLst>
              </a:tr>
              <a:tr h="6148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3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4 (1.07 - 1.45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8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7 (0.89 - 1.28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1 (1.21 - 2.43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4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17764531"/>
                  </a:ext>
                </a:extLst>
              </a:tr>
              <a:tr h="61486">
                <a:tc rowSpan="3">
                  <a:txBody>
                    <a:bodyPr/>
                    <a:lstStyle/>
                    <a:p>
                      <a:pPr marL="0" marR="0" lvl="0" indent="0" algn="l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ms lean mass </a:t>
                      </a:r>
                      <a:r>
                        <a:rPr lang="en-GB" sz="700" b="0" baseline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kg]</a:t>
                      </a:r>
                      <a:endParaRPr lang="en-GB" sz="7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1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8 (0.76 - 1.02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2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4 (0.71 - 0.99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38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1 (0.74 - 1.39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0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47721769"/>
                  </a:ext>
                </a:extLst>
              </a:tr>
              <a:tr h="61486">
                <a:tc vMerge="1">
                  <a:txBody>
                    <a:bodyPr/>
                    <a:lstStyle/>
                    <a:p>
                      <a:pPr algn="ctr" fontAlgn="t"/>
                      <a:endParaRPr lang="fr-CH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lnL w="12700" cmpd="sng"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u="none" strike="noStrike" noProof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2</a:t>
                      </a:r>
                      <a:endParaRPr lang="en-GB" sz="800" b="1" i="0" u="none" strike="noStrike" noProof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 (0.66 - 0.91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 (0.61 - 0.89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1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1 (0.58 - 1.13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55797735"/>
                  </a:ext>
                </a:extLst>
              </a:tr>
              <a:tr h="6148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3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 (0.67 - 0.92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3 (0.60 - 0.89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2 (0.58 - 1.16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23816872"/>
                  </a:ext>
                </a:extLst>
              </a:tr>
              <a:tr h="61486">
                <a:tc rowSpan="3">
                  <a:txBody>
                    <a:bodyPr/>
                    <a:lstStyle/>
                    <a:p>
                      <a:pPr algn="l" fontAlgn="t"/>
                      <a:r>
                        <a:rPr lang="en-GB" sz="10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ms lean percent </a:t>
                      </a:r>
                      <a:r>
                        <a:rPr lang="en-GB" sz="700" b="0" baseline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%]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1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8 (1.10 - 1.49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3 (0.95 - 1.34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4 (1.22 - 2.48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31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64585518"/>
                  </a:ext>
                </a:extLst>
              </a:tr>
              <a:tr h="6148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u="none" strike="noStrike" noProof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2</a:t>
                      </a:r>
                      <a:endParaRPr lang="en-GB" sz="800" b="1" i="0" u="none" strike="noStrike" noProof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6 (1.08 - 1.47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6 (0.88 - 1.26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4 (1.25 - 2.44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20654267"/>
                  </a:ext>
                </a:extLst>
              </a:tr>
              <a:tr h="61486">
                <a:tc vMerge="1">
                  <a:txBody>
                    <a:bodyPr/>
                    <a:lstStyle/>
                    <a:p>
                      <a:pPr algn="ctr" fontAlgn="t"/>
                      <a:endParaRPr lang="fr-CH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lnL w="12700" cmpd="sng"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3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6 (1.08 - 1.47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1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5 (0.87 - 1.26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1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6 (1.24 - 2.48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5312370"/>
                  </a:ext>
                </a:extLst>
              </a:tr>
              <a:tr h="61486">
                <a:tc rowSpan="3">
                  <a:txBody>
                    <a:bodyPr/>
                    <a:lstStyle/>
                    <a:p>
                      <a:pPr marL="0" marR="0" lvl="0" indent="0" algn="l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gs lean mass </a:t>
                      </a:r>
                      <a:r>
                        <a:rPr lang="en-GB" sz="700" b="0" baseline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kg]</a:t>
                      </a:r>
                      <a:endParaRPr lang="en-GB" sz="7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1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0 (0.78 - 1.04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2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 (0.73 - 1.02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4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0 (0.80 - 1.52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2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9965456"/>
                  </a:ext>
                </a:extLst>
              </a:tr>
              <a:tr h="61486">
                <a:tc vMerge="1">
                  <a:txBody>
                    <a:bodyPr/>
                    <a:lstStyle/>
                    <a:p>
                      <a:pPr algn="ctr" fontAlgn="t"/>
                      <a:endParaRPr lang="fr-CH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lnL w="12700" cmpd="sng"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u="none" strike="noStrike" noProof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2</a:t>
                      </a:r>
                      <a:endParaRPr lang="en-GB" sz="800" b="1" i="0" u="none" strike="noStrike" noProof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3 (0.62 - 0.86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 (0.57 - 0.84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9 (0.54 - 1.15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21133792"/>
                  </a:ext>
                </a:extLst>
              </a:tr>
              <a:tr h="6148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3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 (0.61 - 0.85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8 (0.56 - 0.83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1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9 (0.54 - 1.17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939646"/>
                  </a:ext>
                </a:extLst>
              </a:tr>
              <a:tr h="61486">
                <a:tc rowSpan="3">
                  <a:txBody>
                    <a:bodyPr/>
                    <a:lstStyle/>
                    <a:p>
                      <a:pPr algn="l" fontAlgn="t"/>
                      <a:r>
                        <a:rPr lang="en-GB" sz="10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gs lean percent </a:t>
                      </a:r>
                      <a:r>
                        <a:rPr lang="en-GB" sz="700" b="0" baseline="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%]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1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5 (0.99 - 1.33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6 (0.89 - 1.26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2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4 (1.03 - 1.99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3701337"/>
                  </a:ext>
                </a:extLst>
              </a:tr>
              <a:tr h="61486">
                <a:tc vMerge="1">
                  <a:txBody>
                    <a:bodyPr/>
                    <a:lstStyle/>
                    <a:p>
                      <a:pPr algn="ctr" fontAlgn="t"/>
                      <a:endParaRPr lang="fr-CH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>
                    <a:lnL w="12700" cmpd="sng"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u="none" strike="noStrike" noProof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2</a:t>
                      </a:r>
                      <a:endParaRPr lang="en-GB" sz="800" b="1" i="0" u="none" strike="noStrike" noProof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0 (0.95 - 1.28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88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 (0.83 - 1.17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0 (1.01 - 1.94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40552992"/>
                  </a:ext>
                </a:extLst>
              </a:tr>
              <a:tr h="6148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3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1 (0.96 - 1.29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 (0.84 - 1.19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2 (1.02 - 1.98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8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20137873"/>
                  </a:ext>
                </a:extLst>
              </a:tr>
            </a:tbl>
          </a:graphicData>
        </a:graphic>
      </p:graphicFrame>
      <p:sp>
        <p:nvSpPr>
          <p:cNvPr id="3" name="ZoneTexte 2">
            <a:extLst>
              <a:ext uri="{FF2B5EF4-FFF2-40B4-BE49-F238E27FC236}">
                <a16:creationId xmlns:a16="http://schemas.microsoft.com/office/drawing/2014/main" id="{68E7D808-77AB-1251-1C99-753BF114CC12}"/>
              </a:ext>
            </a:extLst>
          </p:cNvPr>
          <p:cNvSpPr txBox="1"/>
          <p:nvPr/>
        </p:nvSpPr>
        <p:spPr>
          <a:xfrm>
            <a:off x="2227931" y="5096639"/>
            <a:ext cx="6024916" cy="1338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Legend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: AFT (accelerated failure time model with Weibull distribution) the ratio represent time-to-event increase/decrease for 1 standard deviation increase in the predictor variable; CI: Confidence Interval; significance level set for p-value under 0.05 noted in 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bold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; Model 1 (M1) as univariate regression; Model 2 (M2) including age, femoral neck BMD T-score and height as covariates. HGS was additionally corrected for weight. M3 additionally including clinical risk factors (CRF): recent falls, actual tobacco status, daily alcohol consumption over 3 units, diabetes, parental hip fracture, current glucocorticoid use and polyarthritis; MOF defined by low trauma fracture at hip, humerus, forearm and vertebral; Vertebral fractures: radiological grades 2-3 or 2 grade 1 fractures; non vertebral fracture: hip, humerus and forearm fractures; HGS: Handgrip Strength; ALM: Appendicular Lean Mass; BMI: Body Mass Index; Lean percent: regional lean mass divided by regional total mass.</a:t>
            </a:r>
            <a:endParaRPr lang="en-GB" sz="900" b="1" dirty="0">
              <a:highlight>
                <a:srgbClr val="00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682753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re 1">
            <a:extLst>
              <a:ext uri="{FF2B5EF4-FFF2-40B4-BE49-F238E27FC236}">
                <a16:creationId xmlns:a16="http://schemas.microsoft.com/office/drawing/2014/main" id="{7EDE5FC6-3BE5-657E-7101-AAF006F3AC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194846" y="909695"/>
            <a:ext cx="5616593" cy="556964"/>
          </a:xfrm>
        </p:spPr>
        <p:txBody>
          <a:bodyPr>
            <a:normAutofit fontScale="90000"/>
          </a:bodyPr>
          <a:lstStyle/>
          <a:p>
            <a:pPr algn="just"/>
            <a:r>
              <a:rPr lang="en-GB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apted</a:t>
            </a:r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: Supp. table S4. 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Prediction of 10 years incident fragility fractures by grip strength (HGS) and appendicular lean mass (ALM) with multivariable logistic regression</a:t>
            </a:r>
          </a:p>
        </p:txBody>
      </p:sp>
      <p:graphicFrame>
        <p:nvGraphicFramePr>
          <p:cNvPr id="8" name="Tableau 7">
            <a:extLst>
              <a:ext uri="{FF2B5EF4-FFF2-40B4-BE49-F238E27FC236}">
                <a16:creationId xmlns:a16="http://schemas.microsoft.com/office/drawing/2014/main" id="{65D1DABF-5D29-18D2-4232-DD793A9E37A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35672662"/>
              </p:ext>
            </p:extLst>
          </p:nvPr>
        </p:nvGraphicFramePr>
        <p:xfrm>
          <a:off x="2288420" y="1485247"/>
          <a:ext cx="5418606" cy="269012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31304">
                  <a:extLst>
                    <a:ext uri="{9D8B030D-6E8A-4147-A177-3AD203B41FA5}">
                      <a16:colId xmlns:a16="http://schemas.microsoft.com/office/drawing/2014/main" val="2263274040"/>
                    </a:ext>
                  </a:extLst>
                </a:gridCol>
                <a:gridCol w="390999">
                  <a:extLst>
                    <a:ext uri="{9D8B030D-6E8A-4147-A177-3AD203B41FA5}">
                      <a16:colId xmlns:a16="http://schemas.microsoft.com/office/drawing/2014/main" val="3123125872"/>
                    </a:ext>
                  </a:extLst>
                </a:gridCol>
                <a:gridCol w="988333">
                  <a:extLst>
                    <a:ext uri="{9D8B030D-6E8A-4147-A177-3AD203B41FA5}">
                      <a16:colId xmlns:a16="http://schemas.microsoft.com/office/drawing/2014/main" val="3384724136"/>
                    </a:ext>
                  </a:extLst>
                </a:gridCol>
                <a:gridCol w="343768">
                  <a:extLst>
                    <a:ext uri="{9D8B030D-6E8A-4147-A177-3AD203B41FA5}">
                      <a16:colId xmlns:a16="http://schemas.microsoft.com/office/drawing/2014/main" val="1193085381"/>
                    </a:ext>
                  </a:extLst>
                </a:gridCol>
                <a:gridCol w="988333">
                  <a:extLst>
                    <a:ext uri="{9D8B030D-6E8A-4147-A177-3AD203B41FA5}">
                      <a16:colId xmlns:a16="http://schemas.microsoft.com/office/drawing/2014/main" val="1188719714"/>
                    </a:ext>
                  </a:extLst>
                </a:gridCol>
                <a:gridCol w="343768">
                  <a:extLst>
                    <a:ext uri="{9D8B030D-6E8A-4147-A177-3AD203B41FA5}">
                      <a16:colId xmlns:a16="http://schemas.microsoft.com/office/drawing/2014/main" val="3118407336"/>
                    </a:ext>
                  </a:extLst>
                </a:gridCol>
                <a:gridCol w="988333">
                  <a:extLst>
                    <a:ext uri="{9D8B030D-6E8A-4147-A177-3AD203B41FA5}">
                      <a16:colId xmlns:a16="http://schemas.microsoft.com/office/drawing/2014/main" val="881306815"/>
                    </a:ext>
                  </a:extLst>
                </a:gridCol>
                <a:gridCol w="343768">
                  <a:extLst>
                    <a:ext uri="{9D8B030D-6E8A-4147-A177-3AD203B41FA5}">
                      <a16:colId xmlns:a16="http://schemas.microsoft.com/office/drawing/2014/main" val="1264471755"/>
                    </a:ext>
                  </a:extLst>
                </a:gridCol>
              </a:tblGrid>
              <a:tr h="219885">
                <a:tc rowSpan="2" gridSpan="2"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dictors and models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 hMerge="1"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fr-CH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jor osteoporotic fractures</a:t>
                      </a:r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n=260)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t"/>
                      <a:endParaRPr lang="fr-CH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tebral fractures</a:t>
                      </a:r>
                    </a:p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G2-3 or 2xG1, n=174)</a:t>
                      </a:r>
                    </a:p>
                  </a:txBody>
                  <a:tcPr marL="3519" marR="3519" marT="3519" marB="0" anchor="ctr">
                    <a:lnL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t"/>
                      <a:endParaRPr lang="fr-CH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12700" cmpd="sng">
                      <a:noFill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 vertebral fractures</a:t>
                      </a:r>
                    </a:p>
                    <a:p>
                      <a:pPr marL="0" marR="0" lvl="0" indent="0" algn="ctr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 106)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t"/>
                      <a:endParaRPr lang="fr-CH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28804865"/>
                  </a:ext>
                </a:extLst>
              </a:tr>
              <a:tr h="168856">
                <a:tc gridSpan="2" vMerge="1">
                  <a:txBody>
                    <a:bodyPr/>
                    <a:lstStyle/>
                    <a:p>
                      <a:pPr algn="ctr" fontAlgn="b"/>
                      <a:endParaRPr lang="fr-CH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 vMerge="1">
                  <a:txBody>
                    <a:bodyPr/>
                    <a:lstStyle/>
                    <a:p>
                      <a:pPr algn="l" fontAlgn="t"/>
                      <a:endParaRPr lang="fr-CH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 </a:t>
                      </a:r>
                      <a:r>
                        <a:rPr lang="en-GB" sz="8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lang="en-GB" sz="8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C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 (95% CI)</a:t>
                      </a:r>
                    </a:p>
                  </a:txBody>
                  <a:tcPr marL="3519" marR="3519" marT="3519" marB="0" anchor="ctr">
                    <a:lnL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C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 (95% CI)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C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13539220"/>
                  </a:ext>
                </a:extLst>
              </a:tr>
              <a:tr h="157349">
                <a:tc gridSpan="3">
                  <a:txBody>
                    <a:bodyPr/>
                    <a:lstStyle/>
                    <a:p>
                      <a:pPr marL="0" marR="0" lvl="0" indent="0" algn="l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1: Univariate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fr-CH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fr-CH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23" rtl="0" eaLnBrk="1" fontAlgn="b" latinLnBrk="0" hangingPunct="1"/>
                      <a:r>
                        <a:rPr lang="fr-CH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23" rtl="0" eaLnBrk="1" fontAlgn="b" latinLnBrk="0" hangingPunct="1"/>
                      <a:endParaRPr lang="fr-CH" sz="8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23" rtl="0" eaLnBrk="1" fontAlgn="b" latinLnBrk="0" hangingPunct="1"/>
                      <a:r>
                        <a:rPr lang="fr-CH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23" rtl="0" eaLnBrk="1" fontAlgn="b" latinLnBrk="0" hangingPunct="1"/>
                      <a:endParaRPr lang="fr-CH" sz="8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23" rtl="0" eaLnBrk="1" fontAlgn="b" latinLnBrk="0" hangingPunct="1"/>
                      <a:r>
                        <a:rPr lang="fr-CH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53409298"/>
                  </a:ext>
                </a:extLst>
              </a:tr>
              <a:tr h="111335">
                <a:tc gridSpan="3">
                  <a:txBody>
                    <a:bodyPr/>
                    <a:lstStyle/>
                    <a:p>
                      <a:pPr marL="0" marR="0" lvl="0" indent="0" algn="l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2: </a:t>
                      </a:r>
                      <a:r>
                        <a:rPr lang="en-GB" sz="9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, BMD and height</a:t>
                      </a:r>
                      <a:endParaRPr lang="en-GB" sz="900" b="1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fr-CH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fr-CH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23" rtl="0" eaLnBrk="1" fontAlgn="b" latinLnBrk="0" hangingPunct="1"/>
                      <a:endParaRPr lang="fr-CH" sz="8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23" rtl="0" eaLnBrk="1" fontAlgn="b" latinLnBrk="0" hangingPunct="1"/>
                      <a:endParaRPr lang="fr-CH" sz="8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56534431"/>
                  </a:ext>
                </a:extLst>
              </a:tr>
              <a:tr h="111335">
                <a:tc gridSpan="3">
                  <a:txBody>
                    <a:bodyPr/>
                    <a:lstStyle/>
                    <a:p>
                      <a:pPr marL="0" marR="0" lvl="0" indent="0" algn="l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3: M2 + CRF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fr-CH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fr-CH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3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23" rtl="0" eaLnBrk="1" fontAlgn="b" latinLnBrk="0" hangingPunct="1"/>
                      <a:endParaRPr lang="fr-CH" sz="8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3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23" rtl="0" eaLnBrk="1" fontAlgn="b" latinLnBrk="0" hangingPunct="1"/>
                      <a:endParaRPr lang="fr-CH" sz="8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40697728"/>
                  </a:ext>
                </a:extLst>
              </a:tr>
              <a:tr h="120750">
                <a:tc rowSpan="3">
                  <a:txBody>
                    <a:bodyPr/>
                    <a:lstStyle/>
                    <a:p>
                      <a:pPr algn="l" fontAlgn="t"/>
                      <a:r>
                        <a:rPr lang="en-GB" sz="9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GS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1</a:t>
                      </a: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9 (0.77-1.02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4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2 (0.78-1.08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2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 (0.70-1.05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17021178"/>
                  </a:ext>
                </a:extLst>
              </a:tr>
              <a:tr h="11608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2</a:t>
                      </a: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2 (0.79-1.08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1 (0.83-1.21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4 (0.67-1.06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69507006"/>
                  </a:ext>
                </a:extLst>
              </a:tr>
              <a:tr h="11608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3</a:t>
                      </a: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2 (0.79-1.08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1 (0.84-1.22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3 (0.66-1.05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55843353"/>
                  </a:ext>
                </a:extLst>
              </a:tr>
              <a:tr h="116088">
                <a:tc rowSpan="3">
                  <a:txBody>
                    <a:bodyPr/>
                    <a:lstStyle/>
                    <a:p>
                      <a:pPr algn="l" fontAlgn="t"/>
                      <a:r>
                        <a:rPr lang="en-GB" sz="9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M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1</a:t>
                      </a: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9 (1.01-1.40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4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7 (1.05-1.55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64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 (0.75-1.24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0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44606134"/>
                  </a:ext>
                </a:extLst>
              </a:tr>
              <a:tr h="116088">
                <a:tc vMerge="1">
                  <a:txBody>
                    <a:bodyPr/>
                    <a:lstStyle/>
                    <a:p>
                      <a:endParaRPr dirty="0"/>
                    </a:p>
                  </a:txBody>
                  <a:tcPr marL="3519" marR="3519" marT="3519" marB="0">
                    <a:lnL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2</a:t>
                      </a: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3 (1.27-1.85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7 (1.26-1.95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9 (0.98-1.70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81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5269397"/>
                  </a:ext>
                </a:extLst>
              </a:tr>
              <a:tr h="116088">
                <a:tc vMerge="1">
                  <a:txBody>
                    <a:bodyPr/>
                    <a:lstStyle/>
                    <a:p>
                      <a:pPr algn="ctr" fontAlgn="t"/>
                      <a:endParaRPr lang="fr-CH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3</a:t>
                      </a: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3 (1.26-1.85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7 (1.26-1.96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1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9 (0.97-1.70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8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80361237"/>
                  </a:ext>
                </a:extLst>
              </a:tr>
              <a:tr h="116088">
                <a:tc rowSpan="3">
                  <a:txBody>
                    <a:bodyPr/>
                    <a:lstStyle/>
                    <a:p>
                      <a:pPr algn="l" fontAlgn="t"/>
                      <a:r>
                        <a:rPr lang="en-GB" sz="9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M / height</a:t>
                      </a:r>
                      <a:r>
                        <a:rPr lang="en-GB" sz="900" b="1" i="0" u="none" strike="noStrike" baseline="30000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GB" sz="900" b="1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1</a:t>
                      </a: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4 (0.96-1.34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2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5 (1.03-1.51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4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9 (0.69-1.15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4264414"/>
                  </a:ext>
                </a:extLst>
              </a:tr>
              <a:tr h="116088">
                <a:tc vMerge="1">
                  <a:txBody>
                    <a:bodyPr/>
                    <a:lstStyle/>
                    <a:p>
                      <a:endParaRPr dirty="0"/>
                    </a:p>
                  </a:txBody>
                  <a:tcPr marL="3519" marR="3519" marT="3519" marB="0">
                    <a:lnL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2</a:t>
                      </a: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4 (1.11-1.60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1 (1.14-1.74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4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0 (0.83-1.44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59035748"/>
                  </a:ext>
                </a:extLst>
              </a:tr>
              <a:tr h="119376">
                <a:tc vMerge="1">
                  <a:txBody>
                    <a:bodyPr/>
                    <a:lstStyle/>
                    <a:p>
                      <a:pPr algn="ctr" fontAlgn="t"/>
                      <a:endParaRPr lang="fr-CH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3</a:t>
                      </a: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4 (1.12-1.61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3 (1.15-1.77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9 (0.82-1.43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6350582"/>
                  </a:ext>
                </a:extLst>
              </a:tr>
              <a:tr h="116088">
                <a:tc rowSpan="3">
                  <a:txBody>
                    <a:bodyPr/>
                    <a:lstStyle/>
                    <a:p>
                      <a:pPr marL="0" marR="0" lvl="0" indent="0" algn="l" defTabSz="914423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M / BMI </a:t>
                      </a:r>
                    </a:p>
                  </a:txBody>
                  <a:tcPr marL="3519" marR="3519" marT="351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1</a:t>
                      </a: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 (0.83-1.16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0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3 (0.84-1.26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0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 (0.75-1.24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0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41903841"/>
                  </a:ext>
                </a:extLst>
              </a:tr>
              <a:tr h="116088">
                <a:tc vMerge="1">
                  <a:txBody>
                    <a:bodyPr/>
                    <a:lstStyle/>
                    <a:p>
                      <a:pPr algn="ctr" fontAlgn="t"/>
                      <a:endParaRPr lang="fr-CH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>
                    <a:lnL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2</a:t>
                      </a: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1 (0.93-1.33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4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9 (0.96-1.47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4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3 (0.79-1.34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4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14694820"/>
                  </a:ext>
                </a:extLst>
              </a:tr>
              <a:tr h="116088">
                <a:tc vMerge="1">
                  <a:txBody>
                    <a:bodyPr/>
                    <a:lstStyle/>
                    <a:p>
                      <a:pPr algn="ctr" fontAlgn="t"/>
                      <a:endParaRPr lang="fr-CH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19" marR="3519" marT="3519" marB="0" anchor="ctr">
                    <a:lnL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3</a:t>
                      </a: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1 (0.92-1.34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4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7 (0.94-1.46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4 (0.80-1.36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58498873"/>
                  </a:ext>
                </a:extLst>
              </a:tr>
            </a:tbl>
          </a:graphicData>
        </a:graphic>
      </p:graphicFrame>
      <p:sp>
        <p:nvSpPr>
          <p:cNvPr id="9" name="ZoneTexte 8">
            <a:extLst>
              <a:ext uri="{FF2B5EF4-FFF2-40B4-BE49-F238E27FC236}">
                <a16:creationId xmlns:a16="http://schemas.microsoft.com/office/drawing/2014/main" id="{ECBB652C-BEDC-7A9C-57BC-296ABAEE2004}"/>
              </a:ext>
            </a:extLst>
          </p:cNvPr>
          <p:cNvSpPr txBox="1"/>
          <p:nvPr/>
        </p:nvSpPr>
        <p:spPr>
          <a:xfrm>
            <a:off x="2198973" y="4172424"/>
            <a:ext cx="5616592" cy="1338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Legend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: OR: odds ratio for 1 standard deviation increase in the predictor variable, as based on multivariate logistic regression (cf. bellow); CI: Confidence Interval; significance level set for p-value under 0.05 noted in 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bold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; Model 1 (M1) as univariate regression; Model 2 (M2) including age, femoral neck BMD T-score and height as covariates. HGS was additionally corrected for weight. M3 additionally including clinical risk factors (CRF): recent falls, actual tobacco status, daily alcohol consumption over 3 units, diabetes, parental hip fracture, current glucocorticoid use and polyarthritis; ; MOF defined by low trauma fracture at hip, humerus, forearm and vertebral; Vertebral fractures: radiological grades 2-3 or 2 grade 1 fractures; non vertebral fracture: hip, humerus and forearm fractures; HGS: Handgrip Strength; ALM: Appendicular Lean Mass; BMI: Body Mass Index.</a:t>
            </a:r>
            <a:endParaRPr lang="en-GB" sz="900" b="1" dirty="0">
              <a:highlight>
                <a:srgbClr val="00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863093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3A3B97AA-24E6-FE25-0C54-C7DC261302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DE8B2-960D-5C43-8820-443305420B8A}" type="slidenum">
              <a:rPr lang="en-GB" smtClean="0"/>
              <a:t>5</a:t>
            </a:fld>
            <a:endParaRPr lang="en-GB"/>
          </a:p>
        </p:txBody>
      </p:sp>
      <p:graphicFrame>
        <p:nvGraphicFramePr>
          <p:cNvPr id="6" name="Tableau 5">
            <a:extLst>
              <a:ext uri="{FF2B5EF4-FFF2-40B4-BE49-F238E27FC236}">
                <a16:creationId xmlns:a16="http://schemas.microsoft.com/office/drawing/2014/main" id="{61D458CA-840E-3179-CCCF-AF91E7A923E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31772064"/>
              </p:ext>
            </p:extLst>
          </p:nvPr>
        </p:nvGraphicFramePr>
        <p:xfrm>
          <a:off x="2862145" y="1829274"/>
          <a:ext cx="4746670" cy="246401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87186">
                  <a:extLst>
                    <a:ext uri="{9D8B030D-6E8A-4147-A177-3AD203B41FA5}">
                      <a16:colId xmlns:a16="http://schemas.microsoft.com/office/drawing/2014/main" val="2056112081"/>
                    </a:ext>
                  </a:extLst>
                </a:gridCol>
                <a:gridCol w="1097266">
                  <a:extLst>
                    <a:ext uri="{9D8B030D-6E8A-4147-A177-3AD203B41FA5}">
                      <a16:colId xmlns:a16="http://schemas.microsoft.com/office/drawing/2014/main" val="3311030308"/>
                    </a:ext>
                  </a:extLst>
                </a:gridCol>
                <a:gridCol w="822871">
                  <a:extLst>
                    <a:ext uri="{9D8B030D-6E8A-4147-A177-3AD203B41FA5}">
                      <a16:colId xmlns:a16="http://schemas.microsoft.com/office/drawing/2014/main" val="780968323"/>
                    </a:ext>
                  </a:extLst>
                </a:gridCol>
                <a:gridCol w="476889">
                  <a:extLst>
                    <a:ext uri="{9D8B030D-6E8A-4147-A177-3AD203B41FA5}">
                      <a16:colId xmlns:a16="http://schemas.microsoft.com/office/drawing/2014/main" val="2115451447"/>
                    </a:ext>
                  </a:extLst>
                </a:gridCol>
                <a:gridCol w="531229">
                  <a:extLst>
                    <a:ext uri="{9D8B030D-6E8A-4147-A177-3AD203B41FA5}">
                      <a16:colId xmlns:a16="http://schemas.microsoft.com/office/drawing/2014/main" val="3536772371"/>
                    </a:ext>
                  </a:extLst>
                </a:gridCol>
                <a:gridCol w="531229">
                  <a:extLst>
                    <a:ext uri="{9D8B030D-6E8A-4147-A177-3AD203B41FA5}">
                      <a16:colId xmlns:a16="http://schemas.microsoft.com/office/drawing/2014/main" val="2534848568"/>
                    </a:ext>
                  </a:extLst>
                </a:gridCol>
              </a:tblGrid>
              <a:tr h="304011">
                <a:tc>
                  <a:txBody>
                    <a:bodyPr/>
                    <a:lstStyle/>
                    <a:p>
                      <a:pPr algn="ctr" fontAlgn="b"/>
                      <a:endParaRPr lang="fr-CH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2" marR="7552" marT="755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CH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utcome</a:t>
                      </a:r>
                      <a:r>
                        <a:rPr lang="fr-CH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: fractures</a:t>
                      </a:r>
                      <a:endParaRPr lang="fr-CH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2" marR="7552" marT="755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CH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 (95% CI)</a:t>
                      </a:r>
                      <a:endParaRPr lang="fr-CH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2" marR="7552" marT="755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CH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fr-CH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2" marR="7552" marT="755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CH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nsitivity</a:t>
                      </a:r>
                      <a:endParaRPr lang="fr-CH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2" marR="7552" marT="755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CH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cificity</a:t>
                      </a:r>
                      <a:endParaRPr lang="fr-CH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2" marR="7552" marT="755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85372643"/>
                  </a:ext>
                </a:extLst>
              </a:tr>
              <a:tr h="180000">
                <a:tc rowSpan="3">
                  <a:txBody>
                    <a:bodyPr/>
                    <a:lstStyle/>
                    <a:p>
                      <a:pPr algn="ctr" fontAlgn="t"/>
                      <a:r>
                        <a:rPr lang="fr-CH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M/height</a:t>
                      </a:r>
                      <a:r>
                        <a:rPr lang="fr-CH" sz="800" b="1" u="none" strike="noStrike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</a:t>
                      </a:r>
                      <a:r>
                        <a:rPr lang="fr-CH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5.5kg/m</a:t>
                      </a:r>
                      <a:r>
                        <a:rPr lang="fr-CH" sz="800" b="1" u="none" strike="noStrike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  <a:p>
                      <a:pPr algn="ctr" fontAlgn="t"/>
                      <a:r>
                        <a:rPr lang="fr-CH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EWGSOP, 2019)</a:t>
                      </a:r>
                    </a:p>
                  </a:txBody>
                  <a:tcPr marL="7552" marR="7552" marT="755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F</a:t>
                      </a:r>
                      <a:endParaRPr lang="fr-CH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2" marR="7552" marT="755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3 (0.39. 1.37)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7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59838868"/>
                  </a:ext>
                </a:extLst>
              </a:tr>
              <a:tr h="180000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7552" marR="7552" marT="7552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tebral</a:t>
                      </a:r>
                      <a:endParaRPr lang="fr-CH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2" marR="7552" marT="755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7 (0.26. 1.28)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3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1105040"/>
                  </a:ext>
                </a:extLst>
              </a:tr>
              <a:tr h="180000">
                <a:tc vMerge="1">
                  <a:txBody>
                    <a:bodyPr/>
                    <a:lstStyle/>
                    <a:p>
                      <a:endParaRPr dirty="0"/>
                    </a:p>
                  </a:txBody>
                  <a:tcPr marL="7552" marR="7552" marT="7552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 </a:t>
                      </a:r>
                      <a:r>
                        <a:rPr lang="fr-CH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tebral</a:t>
                      </a:r>
                      <a:endParaRPr lang="fr-CH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2" marR="7552" marT="7552" marB="0" anchor="ctr">
                    <a:lnB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 (0.40. 2.22)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0048916"/>
                  </a:ext>
                </a:extLst>
              </a:tr>
              <a:tr h="180000">
                <a:tc rowSpan="3">
                  <a:txBody>
                    <a:bodyPr/>
                    <a:lstStyle/>
                    <a:p>
                      <a:pPr algn="ctr" fontAlgn="t"/>
                      <a:r>
                        <a:rPr lang="fr-CH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M &lt;15kg</a:t>
                      </a:r>
                    </a:p>
                    <a:p>
                      <a:pPr algn="ctr" fontAlgn="t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EWGSOP, 2019)</a:t>
                      </a:r>
                    </a:p>
                  </a:txBody>
                  <a:tcPr marL="7552" marR="7552" marT="755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23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H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F</a:t>
                      </a:r>
                      <a:endParaRPr lang="fr-CH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2" marR="7552" marT="755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 (0.48. 1.16)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87873577"/>
                  </a:ext>
                </a:extLst>
              </a:tr>
              <a:tr h="180000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7552" marR="7552" marT="7552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tebral</a:t>
                      </a:r>
                      <a:endParaRPr lang="fr-CH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2" marR="7552" marT="755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 (0.41. 1.18)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48033230"/>
                  </a:ext>
                </a:extLst>
              </a:tr>
              <a:tr h="180000">
                <a:tc vMerge="1">
                  <a:txBody>
                    <a:bodyPr/>
                    <a:lstStyle/>
                    <a:p>
                      <a:endParaRPr dirty="0"/>
                    </a:p>
                  </a:txBody>
                  <a:tcPr marL="7552" marR="7552" marT="7552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 </a:t>
                      </a:r>
                      <a:r>
                        <a:rPr lang="fr-CH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tebral</a:t>
                      </a:r>
                      <a:endParaRPr lang="fr-CH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2" marR="7552" marT="755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 (0.51. 1.63)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62621819"/>
                  </a:ext>
                </a:extLst>
              </a:tr>
              <a:tr h="180000">
                <a:tc rowSpan="3">
                  <a:txBody>
                    <a:bodyPr/>
                    <a:lstStyle/>
                    <a:p>
                      <a:pPr algn="ctr" fontAlgn="t"/>
                      <a:r>
                        <a:rPr lang="fr-CH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GS &lt;16kg</a:t>
                      </a:r>
                    </a:p>
                    <a:p>
                      <a:pPr algn="ctr" fontAlgn="t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EWGSOP, 2019)</a:t>
                      </a:r>
                    </a:p>
                  </a:txBody>
                  <a:tcPr marL="7552" marR="7552" marT="755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F</a:t>
                      </a:r>
                      <a:endParaRPr lang="fr-CH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2" marR="7552" marT="755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6 (0.83. 2.24)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3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50708866"/>
                  </a:ext>
                </a:extLst>
              </a:tr>
              <a:tr h="180000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7552" marR="7552" marT="7552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tebral</a:t>
                      </a:r>
                      <a:endParaRPr lang="fr-CH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2" marR="7552" marT="755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7 (0.78. 2.41)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6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3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71249092"/>
                  </a:ext>
                </a:extLst>
              </a:tr>
              <a:tr h="180000">
                <a:tc vMerge="1">
                  <a:txBody>
                    <a:bodyPr/>
                    <a:lstStyle/>
                    <a:p>
                      <a:endParaRPr dirty="0"/>
                    </a:p>
                  </a:txBody>
                  <a:tcPr marL="7552" marR="7552" marT="7552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 </a:t>
                      </a:r>
                      <a:r>
                        <a:rPr lang="fr-CH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tebral</a:t>
                      </a:r>
                      <a:endParaRPr lang="fr-CH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2" marR="7552" marT="755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0 (0.44. 1.82)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89772014"/>
                  </a:ext>
                </a:extLst>
              </a:tr>
              <a:tr h="180000">
                <a:tc rowSpan="3">
                  <a:txBody>
                    <a:bodyPr/>
                    <a:lstStyle/>
                    <a:p>
                      <a:pPr algn="ctr" fontAlgn="t"/>
                      <a:r>
                        <a:rPr lang="fr-CH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GS &lt;20kg </a:t>
                      </a:r>
                    </a:p>
                    <a:p>
                      <a:pPr algn="ctr" fontAlgn="t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SDOC, 2020)</a:t>
                      </a:r>
                    </a:p>
                  </a:txBody>
                  <a:tcPr marL="7552" marR="7552" marT="755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F</a:t>
                      </a:r>
                      <a:endParaRPr lang="fr-CH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2" marR="7552" marT="755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9 (1.29. 2.49)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8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3059970"/>
                  </a:ext>
                </a:extLst>
              </a:tr>
              <a:tr h="180000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7552" marR="7552" marT="7552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tebral</a:t>
                      </a:r>
                      <a:endParaRPr lang="fr-CH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2" marR="7552" marT="755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4 (1.12. 2.39)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40704921"/>
                  </a:ext>
                </a:extLst>
              </a:tr>
              <a:tr h="180000">
                <a:tc vMerge="1">
                  <a:txBody>
                    <a:bodyPr/>
                    <a:lstStyle/>
                    <a:p>
                      <a:endParaRPr dirty="0"/>
                    </a:p>
                  </a:txBody>
                  <a:tcPr marL="7552" marR="7552" marT="7552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H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 </a:t>
                      </a:r>
                      <a:r>
                        <a:rPr lang="fr-CH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tebral</a:t>
                      </a:r>
                      <a:endParaRPr lang="fr-CH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552" marR="7552" marT="755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5 (0.87. 2.09)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9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45191250"/>
                  </a:ext>
                </a:extLst>
              </a:tr>
            </a:tbl>
          </a:graphicData>
        </a:graphic>
      </p:graphicFrame>
      <p:sp>
        <p:nvSpPr>
          <p:cNvPr id="7" name="Titre 1">
            <a:extLst>
              <a:ext uri="{FF2B5EF4-FFF2-40B4-BE49-F238E27FC236}">
                <a16:creationId xmlns:a16="http://schemas.microsoft.com/office/drawing/2014/main" id="{1A86F7D7-93CB-B16F-89F9-7FABEF26CD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773380" y="1052919"/>
            <a:ext cx="4910935" cy="877907"/>
          </a:xfrm>
        </p:spPr>
        <p:txBody>
          <a:bodyPr>
            <a:normAutofit fontScale="90000"/>
          </a:bodyPr>
          <a:lstStyle/>
          <a:p>
            <a:pPr algn="just"/>
            <a:r>
              <a:rPr lang="en-GB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w: </a:t>
            </a:r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Supp. table S5. 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10 years incident fragility fractures odds based on sarcopenia thresholds for handgrip strength (HGS) and appendicular lean mass (ALM)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C139DE02-4F2E-DFA7-1F73-312BC2A19F02}"/>
              </a:ext>
            </a:extLst>
          </p:cNvPr>
          <p:cNvSpPr txBox="1"/>
          <p:nvPr/>
        </p:nvSpPr>
        <p:spPr>
          <a:xfrm>
            <a:off x="2773381" y="4284810"/>
            <a:ext cx="491093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Legend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: OR: odds ratio by subgroups; significance level set for p-value under 0.05; MOF defined by low trauma fracture at hip, humerus, forearm and vertebral; Vertebral fractures: radiological grades 2-3 or 2 grade 1 fractures; non vertebral fracture: hip, humerus and forearm fractures; HGS: Handgrip Strength; ALM: Appendicular Lean Mass. EWGSOP: European Working Group on Sarcopenia in Older People; SDOC: Sarcopenia Definitions and Outcomes Consortium.</a:t>
            </a:r>
            <a:endParaRPr lang="en-GB" sz="900" b="1" dirty="0">
              <a:highlight>
                <a:srgbClr val="00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746890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1D9A78"/>
      </a:accent1>
      <a:accent2>
        <a:srgbClr val="8BC145"/>
      </a:accent2>
      <a:accent3>
        <a:srgbClr val="36AFCE"/>
      </a:accent3>
      <a:accent4>
        <a:srgbClr val="1D6FA9"/>
      </a:accent4>
      <a:accent5>
        <a:srgbClr val="B74919"/>
      </a:accent5>
      <a:accent6>
        <a:srgbClr val="F19D19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AE6F2518-B084-4896-AF52-66CC2144AA26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5727</TotalTime>
  <Words>2467</Words>
  <Application>Microsoft Macintosh PowerPoint</Application>
  <PresentationFormat>Format A4 (210 x 297 mm)</PresentationFormat>
  <Paragraphs>655</Paragraphs>
  <Slides>5</Slides>
  <Notes>3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New: Supp. Table S3. Prediction of 10 years incident fragility fractures by lean mass with accelerated failure time model</vt:lpstr>
      <vt:lpstr>Adapted: Supp. table S4. Prediction of 10 years incident fragility fractures by grip strength (HGS) and appendicular lean mass (ALM) with multivariable logistic regression</vt:lpstr>
      <vt:lpstr>New: Supp. table S5. 10 years incident fragility fractures odds based on sarcopenia thresholds for handgrip strength (HGS) and appendicular lean mass (ALM)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ragility fracture prediction in Swiss post-menopausal women</dc:title>
  <dc:creator>Colin Vendrami</dc:creator>
  <cp:lastModifiedBy>Vendrami Colin</cp:lastModifiedBy>
  <cp:revision>629</cp:revision>
  <dcterms:created xsi:type="dcterms:W3CDTF">2022-04-07T07:15:03Z</dcterms:created>
  <dcterms:modified xsi:type="dcterms:W3CDTF">2025-03-15T13:55:12Z</dcterms:modified>
</cp:coreProperties>
</file>